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3.xml" ContentType="application/vnd.openxmlformats-officedocument.themeOverride+xml"/>
  <Override PartName="/ppt/notesSlides/notesSlide1.xml" ContentType="application/vnd.openxmlformats-officedocument.presentationml.notesSlide+xml"/>
  <Override PartName="/ppt/charts/chart5.xml" ContentType="application/vnd.openxmlformats-officedocument.drawingml.chart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1" r:id="rId2"/>
    <p:sldId id="267" r:id="rId3"/>
    <p:sldId id="270" r:id="rId4"/>
    <p:sldId id="257" r:id="rId5"/>
    <p:sldId id="259" r:id="rId6"/>
    <p:sldId id="258" r:id="rId7"/>
    <p:sldId id="271" r:id="rId8"/>
    <p:sldId id="2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60" d="100"/>
          <a:sy n="60" d="100"/>
        </p:scale>
        <p:origin x="34" y="6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\\research1\research_shared\CBRC\J.LEE_LAB\Chris%20Lucido\Beta2%20AR%20Project\Growth%20assays\Cell%20Counting\2018.3.7%20Primary%20HTE%20Propranolol%2048hr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research1\research_shared\CBRC\J.LEE_LAB\Chris%20Lucido\Beta2%20AR%20Project\Growth%20assays\MTT%20Assays\7.25.16.meerl%20and%20MLM3%20propranolol%20dose%20response%2048h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1.xlsx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614319703012207"/>
          <c:y val="0.21599269199421095"/>
          <c:w val="0.66698427320541487"/>
          <c:h val="0.6862975561176756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47C-40DC-8635-6441229E3FD4}"/>
              </c:ext>
            </c:extLst>
          </c:dPt>
          <c:errBars>
            <c:errBarType val="both"/>
            <c:errValType val="cust"/>
            <c:noEndCap val="0"/>
            <c:plus>
              <c:numRef>
                <c:f>(Sheet1!$S$6,Sheet1!$S$10)</c:f>
                <c:numCache>
                  <c:formatCode>General</c:formatCode>
                  <c:ptCount val="2"/>
                  <c:pt idx="0">
                    <c:v>7.0293097189113718</c:v>
                  </c:pt>
                  <c:pt idx="1">
                    <c:v>8.6297613596245757</c:v>
                  </c:pt>
                </c:numCache>
              </c:numRef>
            </c:plus>
            <c:minus>
              <c:numRef>
                <c:f>(Sheet1!$S$6,Sheet1!$S$10)</c:f>
                <c:numCache>
                  <c:formatCode>General</c:formatCode>
                  <c:ptCount val="2"/>
                  <c:pt idx="0">
                    <c:v>7.0293097189113718</c:v>
                  </c:pt>
                  <c:pt idx="1">
                    <c:v>8.62976135962457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L$4,Sheet1!$L$8)</c:f>
              <c:strCache>
                <c:ptCount val="2"/>
                <c:pt idx="0">
                  <c:v>Control</c:v>
                </c:pt>
                <c:pt idx="1">
                  <c:v>Pro</c:v>
                </c:pt>
              </c:strCache>
            </c:strRef>
          </c:cat>
          <c:val>
            <c:numRef>
              <c:f>(Sheet1!$Q$6,Sheet1!$Q$10)</c:f>
              <c:numCache>
                <c:formatCode>General</c:formatCode>
                <c:ptCount val="2"/>
                <c:pt idx="0">
                  <c:v>100.00000000000001</c:v>
                </c:pt>
                <c:pt idx="1">
                  <c:v>77.7777777777777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47C-40DC-8635-6441229E3F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1449424"/>
        <c:axId val="591448112"/>
      </c:barChart>
      <c:catAx>
        <c:axId val="591449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1448112"/>
        <c:crosses val="autoZero"/>
        <c:auto val="1"/>
        <c:lblAlgn val="ctr"/>
        <c:lblOffset val="100"/>
        <c:noMultiLvlLbl val="0"/>
      </c:catAx>
      <c:valAx>
        <c:axId val="591448112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0" i="0" kern="1200" baseline="0">
                    <a:solidFill>
                      <a:srgbClr val="000000"/>
                    </a:solidFill>
                    <a:effectLst/>
                  </a:rPr>
                  <a:t>% Cell Number Relaitve to Control</a:t>
                </a:r>
                <a:endParaRPr lang="en-US" sz="900">
                  <a:effectLst/>
                </a:endParaRPr>
              </a:p>
            </c:rich>
          </c:tx>
          <c:layout>
            <c:manualLayout>
              <c:xMode val="edge"/>
              <c:yMode val="edge"/>
              <c:x val="9.1563027126224578E-2"/>
              <c:y val="0.268099787432391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1449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9790626113261817"/>
          <c:y val="9.2592592592592587E-2"/>
          <c:w val="0.62342562966582227"/>
          <c:h val="0.767123565520003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ombo Graphs'!$B$3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ombo Graphs'!$B$12:$B$14</c:f>
                <c:numCache>
                  <c:formatCode>General</c:formatCode>
                  <c:ptCount val="3"/>
                  <c:pt idx="0">
                    <c:v>1.4068994583033507</c:v>
                  </c:pt>
                  <c:pt idx="1">
                    <c:v>1.7447164561081439</c:v>
                  </c:pt>
                  <c:pt idx="2">
                    <c:v>1.9610549391243699</c:v>
                  </c:pt>
                </c:numCache>
              </c:numRef>
            </c:plus>
            <c:minus>
              <c:numRef>
                <c:f>'Combo Graphs'!$B$12:$B$14</c:f>
                <c:numCache>
                  <c:formatCode>General</c:formatCode>
                  <c:ptCount val="3"/>
                  <c:pt idx="0">
                    <c:v>1.4068994583033507</c:v>
                  </c:pt>
                  <c:pt idx="1">
                    <c:v>1.7447164561081439</c:v>
                  </c:pt>
                  <c:pt idx="2">
                    <c:v>1.96105493912436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Combo Graphs'!$J$4:$J$6</c:f>
              <c:strCache>
                <c:ptCount val="3"/>
                <c:pt idx="0">
                  <c:v>SCC1</c:v>
                </c:pt>
                <c:pt idx="1">
                  <c:v>SCC19</c:v>
                </c:pt>
                <c:pt idx="2">
                  <c:v>SCC47</c:v>
                </c:pt>
              </c:strCache>
            </c:strRef>
          </c:cat>
          <c:val>
            <c:numRef>
              <c:f>'Combo Graphs'!$B$4:$B$6</c:f>
              <c:numCache>
                <c:formatCode>General</c:formatCode>
                <c:ptCount val="3"/>
                <c:pt idx="0">
                  <c:v>99.999999999999986</c:v>
                </c:pt>
                <c:pt idx="1">
                  <c:v>100.00000000000003</c:v>
                </c:pt>
                <c:pt idx="2">
                  <c:v>100.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D5-4667-B442-9FDF38F30ADD}"/>
            </c:ext>
          </c:extLst>
        </c:ser>
        <c:ser>
          <c:idx val="2"/>
          <c:order val="2"/>
          <c:tx>
            <c:v>Atenolol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DED5-4667-B442-9FDF38F30AD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Combo Graphs'!$G$12:$G$14</c:f>
                <c:numCache>
                  <c:formatCode>General</c:formatCode>
                  <c:ptCount val="3"/>
                  <c:pt idx="0">
                    <c:v>2.5333604389916036</c:v>
                  </c:pt>
                  <c:pt idx="1">
                    <c:v>3.7822287496675089</c:v>
                  </c:pt>
                  <c:pt idx="2">
                    <c:v>1.9195250072056489</c:v>
                  </c:pt>
                </c:numCache>
              </c:numRef>
            </c:plus>
            <c:minus>
              <c:numRef>
                <c:f>'Combo Graphs'!$G$12:$G$14</c:f>
                <c:numCache>
                  <c:formatCode>General</c:formatCode>
                  <c:ptCount val="3"/>
                  <c:pt idx="0">
                    <c:v>2.5333604389916036</c:v>
                  </c:pt>
                  <c:pt idx="1">
                    <c:v>3.7822287496675089</c:v>
                  </c:pt>
                  <c:pt idx="2">
                    <c:v>1.9195250072056489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Combo Graphs'!$J$4:$J$6</c:f>
              <c:strCache>
                <c:ptCount val="3"/>
                <c:pt idx="0">
                  <c:v>SCC1</c:v>
                </c:pt>
                <c:pt idx="1">
                  <c:v>SCC19</c:v>
                </c:pt>
                <c:pt idx="2">
                  <c:v>SCC47</c:v>
                </c:pt>
              </c:strCache>
            </c:strRef>
          </c:cat>
          <c:val>
            <c:numRef>
              <c:f>'Combo Graphs'!$G$4:$G$6</c:f>
              <c:numCache>
                <c:formatCode>General</c:formatCode>
                <c:ptCount val="3"/>
                <c:pt idx="0">
                  <c:v>101.92754248607773</c:v>
                </c:pt>
                <c:pt idx="1">
                  <c:v>94.383919469928671</c:v>
                </c:pt>
                <c:pt idx="2">
                  <c:v>89.6279858048447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D5-4667-B442-9FDF38F30ADD}"/>
            </c:ext>
          </c:extLst>
        </c:ser>
        <c:ser>
          <c:idx val="4"/>
          <c:order val="4"/>
          <c:tx>
            <c:v>ICI-118,551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DED5-4667-B442-9FDF38F30ADD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DED5-4667-B442-9FDF38F30ADD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DED5-4667-B442-9FDF38F30AD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Combo Graphs'!$P$12:$P$14</c:f>
                <c:numCache>
                  <c:formatCode>General</c:formatCode>
                  <c:ptCount val="3"/>
                  <c:pt idx="0">
                    <c:v>4.1898585397936614</c:v>
                  </c:pt>
                  <c:pt idx="1">
                    <c:v>0.79053665747134749</c:v>
                  </c:pt>
                  <c:pt idx="2">
                    <c:v>2.2954806184214385</c:v>
                  </c:pt>
                </c:numCache>
              </c:numRef>
            </c:plus>
            <c:minus>
              <c:numRef>
                <c:f>'Combo Graphs'!$P$12:$P$14</c:f>
                <c:numCache>
                  <c:formatCode>General</c:formatCode>
                  <c:ptCount val="3"/>
                  <c:pt idx="0">
                    <c:v>4.1898585397936614</c:v>
                  </c:pt>
                  <c:pt idx="1">
                    <c:v>0.79053665747134749</c:v>
                  </c:pt>
                  <c:pt idx="2">
                    <c:v>2.2954806184214385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Combo Graphs'!$J$4:$J$6</c:f>
              <c:strCache>
                <c:ptCount val="3"/>
                <c:pt idx="0">
                  <c:v>SCC1</c:v>
                </c:pt>
                <c:pt idx="1">
                  <c:v>SCC19</c:v>
                </c:pt>
                <c:pt idx="2">
                  <c:v>SCC47</c:v>
                </c:pt>
              </c:strCache>
            </c:strRef>
          </c:cat>
          <c:val>
            <c:numRef>
              <c:f>'Combo Graphs'!$P$4:$P$6</c:f>
              <c:numCache>
                <c:formatCode>General</c:formatCode>
                <c:ptCount val="3"/>
                <c:pt idx="0">
                  <c:v>82.31099603394776</c:v>
                </c:pt>
                <c:pt idx="1">
                  <c:v>57.917622324159026</c:v>
                </c:pt>
                <c:pt idx="2">
                  <c:v>71.333464423157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ED5-4667-B442-9FDF38F30A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3063912"/>
        <c:axId val="553065224"/>
        <c:extLst>
          <c:ext xmlns:c15="http://schemas.microsoft.com/office/drawing/2012/chart" uri="{02D57815-91ED-43cb-92C2-25804820EDAC}">
            <c15:filteredBarSeries>
              <c15:ser>
                <c:idx val="1"/>
                <c:order val="1"/>
                <c:tx>
                  <c:strRef>
                    <c:extLst>
                      <c:ext uri="{02D57815-91ED-43cb-92C2-25804820EDAC}">
                        <c15:formulaRef>
                          <c15:sqref>'Combo Graphs'!$F$3</c15:sqref>
                        </c15:formulaRef>
                      </c:ext>
                    </c:extLst>
                    <c:strCache>
                      <c:ptCount val="1"/>
                      <c:pt idx="0">
                        <c:v>20</c:v>
                      </c:pt>
                    </c:strCache>
                  </c:strRef>
                </c:tx>
                <c:spPr>
                  <a:solidFill>
                    <a:schemeClr val="accent2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'Combo Graphs'!$J$4:$J$6</c15:sqref>
                        </c15:formulaRef>
                      </c:ext>
                    </c:extLst>
                    <c:strCache>
                      <c:ptCount val="3"/>
                      <c:pt idx="0">
                        <c:v>SCC1</c:v>
                      </c:pt>
                      <c:pt idx="1">
                        <c:v>SCC19</c:v>
                      </c:pt>
                      <c:pt idx="2">
                        <c:v>SCC47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Combo Graphs'!$F$4:$F$6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96.025727965805658</c:v>
                      </c:pt>
                      <c:pt idx="1">
                        <c:v>96.218781855249759</c:v>
                      </c:pt>
                      <c:pt idx="2">
                        <c:v>88.476268059964241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7-DED5-4667-B442-9FDF38F30ADD}"/>
                  </c:ext>
                </c:extLst>
              </c15:ser>
            </c15:filteredBarSeries>
            <c15:filteredBa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ombo Graphs'!$N$3</c15:sqref>
                        </c15:formulaRef>
                      </c:ext>
                    </c:extLst>
                    <c:strCache>
                      <c:ptCount val="1"/>
                      <c:pt idx="0">
                        <c:v>10</c:v>
                      </c:pt>
                    </c:strCache>
                  </c:strRef>
                </c:tx>
                <c:spPr>
                  <a:solidFill>
                    <a:schemeClr val="accent4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ombo Graphs'!$J$4:$J$6</c15:sqref>
                        </c15:formulaRef>
                      </c:ext>
                    </c:extLst>
                    <c:strCache>
                      <c:ptCount val="3"/>
                      <c:pt idx="0">
                        <c:v>SCC1</c:v>
                      </c:pt>
                      <c:pt idx="1">
                        <c:v>SCC19</c:v>
                      </c:pt>
                      <c:pt idx="2">
                        <c:v>SCC47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ombo Graphs'!$N$4:$N$6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99.369130550931928</c:v>
                      </c:pt>
                      <c:pt idx="1">
                        <c:v>89.635894495412856</c:v>
                      </c:pt>
                      <c:pt idx="2">
                        <c:v>84.869425171119062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8-DED5-4667-B442-9FDF38F30ADD}"/>
                  </c:ext>
                </c:extLst>
              </c15:ser>
            </c15:filteredBarSeries>
          </c:ext>
        </c:extLst>
      </c:barChart>
      <c:catAx>
        <c:axId val="553063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3065224"/>
        <c:crosses val="autoZero"/>
        <c:auto val="1"/>
        <c:lblAlgn val="ctr"/>
        <c:lblOffset val="100"/>
        <c:noMultiLvlLbl val="0"/>
      </c:catAx>
      <c:valAx>
        <c:axId val="5530652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/>
                  <a:t>% Proliferation Relative to Control</a:t>
                </a:r>
              </a:p>
            </c:rich>
          </c:tx>
          <c:layout>
            <c:manualLayout>
              <c:xMode val="edge"/>
              <c:yMode val="edge"/>
              <c:x val="2.456732184353852E-2"/>
              <c:y val="0.109688954331404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30639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205697525407232"/>
          <c:y val="7.2626494604841066E-2"/>
          <c:w val="0.26320153377054284"/>
          <c:h val="0.1741914552347623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597584311477227"/>
          <c:y val="5.0000214100670126E-2"/>
          <c:w val="0.65341992044094421"/>
          <c:h val="0.7405755189692198"/>
        </c:manualLayout>
      </c:layout>
      <c:scatterChart>
        <c:scatterStyle val="lineMarker"/>
        <c:varyColors val="0"/>
        <c:ser>
          <c:idx val="0"/>
          <c:order val="0"/>
          <c:tx>
            <c:v>MLM3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28575" cap="rnd">
                <a:solidFill>
                  <a:schemeClr val="accent1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1"/>
            <c:trendlineLbl>
              <c:layout>
                <c:manualLayout>
                  <c:x val="-0.15896469496191024"/>
                  <c:y val="-0.3377913931188775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/>
                      <a:t>MLM3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96 hrs'!$B$44:$F$44</c:f>
                <c:numCache>
                  <c:formatCode>General</c:formatCode>
                  <c:ptCount val="5"/>
                  <c:pt idx="0">
                    <c:v>1.0296171033739003</c:v>
                  </c:pt>
                  <c:pt idx="1">
                    <c:v>1.4940254242550182</c:v>
                  </c:pt>
                  <c:pt idx="2">
                    <c:v>2.0935258719578944</c:v>
                  </c:pt>
                  <c:pt idx="3">
                    <c:v>2.4025498587577587</c:v>
                  </c:pt>
                  <c:pt idx="4">
                    <c:v>2.3363969572585335</c:v>
                  </c:pt>
                </c:numCache>
              </c:numRef>
            </c:plus>
            <c:minus>
              <c:numRef>
                <c:f>'96 hrs'!$B$44:$F$44</c:f>
                <c:numCache>
                  <c:formatCode>General</c:formatCode>
                  <c:ptCount val="5"/>
                  <c:pt idx="0">
                    <c:v>1.0296171033739003</c:v>
                  </c:pt>
                  <c:pt idx="1">
                    <c:v>1.4940254242550182</c:v>
                  </c:pt>
                  <c:pt idx="2">
                    <c:v>2.0935258719578944</c:v>
                  </c:pt>
                  <c:pt idx="3">
                    <c:v>2.4025498587577587</c:v>
                  </c:pt>
                  <c:pt idx="4">
                    <c:v>2.33639695725853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96 hrs'!$B$1:$F$1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20</c:v>
                </c:pt>
                <c:pt idx="3">
                  <c:v>100</c:v>
                </c:pt>
                <c:pt idx="4">
                  <c:v>200</c:v>
                </c:pt>
              </c:numCache>
            </c:numRef>
          </c:xVal>
          <c:yVal>
            <c:numRef>
              <c:f>'96 hrs'!$B$43:$F$43</c:f>
              <c:numCache>
                <c:formatCode>General</c:formatCode>
                <c:ptCount val="5"/>
                <c:pt idx="0">
                  <c:v>100</c:v>
                </c:pt>
                <c:pt idx="1">
                  <c:v>82.790915476469195</c:v>
                </c:pt>
                <c:pt idx="2">
                  <c:v>74.860353881660345</c:v>
                </c:pt>
                <c:pt idx="3">
                  <c:v>27.745258721610853</c:v>
                </c:pt>
                <c:pt idx="4">
                  <c:v>1.07870354885105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C3A-40C2-94A0-712AA3B10EFA}"/>
            </c:ext>
          </c:extLst>
        </c:ser>
        <c:ser>
          <c:idx val="1"/>
          <c:order val="1"/>
          <c:tx>
            <c:v>mEERL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2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25400" cap="rnd">
                <a:solidFill>
                  <a:srgbClr val="C00000"/>
                </a:solidFill>
                <a:prstDash val="solid"/>
              </a:ln>
              <a:effectLst/>
            </c:spPr>
            <c:trendlineType val="poly"/>
            <c:order val="2"/>
            <c:dispRSqr val="0"/>
            <c:dispEq val="1"/>
            <c:trendlineLbl>
              <c:layout>
                <c:manualLayout>
                  <c:x val="6.8744782394415713E-2"/>
                  <c:y val="-0.43598047401888368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/>
                      <a:t>mEERL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96 hrs'!$B$57:$F$57</c:f>
                <c:numCache>
                  <c:formatCode>General</c:formatCode>
                  <c:ptCount val="5"/>
                  <c:pt idx="0">
                    <c:v>2.5548620175426273</c:v>
                  </c:pt>
                  <c:pt idx="1">
                    <c:v>3.0301998338658982</c:v>
                  </c:pt>
                  <c:pt idx="2">
                    <c:v>2.7707714857863603</c:v>
                  </c:pt>
                  <c:pt idx="3">
                    <c:v>1.7801617768396407</c:v>
                  </c:pt>
                  <c:pt idx="4">
                    <c:v>0.64234471601146359</c:v>
                  </c:pt>
                </c:numCache>
              </c:numRef>
            </c:plus>
            <c:minus>
              <c:numRef>
                <c:f>'96 hrs'!$B$57:$F$57</c:f>
                <c:numCache>
                  <c:formatCode>General</c:formatCode>
                  <c:ptCount val="5"/>
                  <c:pt idx="0">
                    <c:v>2.5548620175426273</c:v>
                  </c:pt>
                  <c:pt idx="1">
                    <c:v>3.0301998338658982</c:v>
                  </c:pt>
                  <c:pt idx="2">
                    <c:v>2.7707714857863603</c:v>
                  </c:pt>
                  <c:pt idx="3">
                    <c:v>1.7801617768396407</c:v>
                  </c:pt>
                  <c:pt idx="4">
                    <c:v>0.642344716011463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96 hrs'!$B$1:$F$1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20</c:v>
                </c:pt>
                <c:pt idx="3">
                  <c:v>100</c:v>
                </c:pt>
                <c:pt idx="4">
                  <c:v>200</c:v>
                </c:pt>
              </c:numCache>
            </c:numRef>
          </c:xVal>
          <c:yVal>
            <c:numRef>
              <c:f>'96 hrs'!$B$56:$F$56</c:f>
              <c:numCache>
                <c:formatCode>General</c:formatCode>
                <c:ptCount val="5"/>
                <c:pt idx="0">
                  <c:v>100</c:v>
                </c:pt>
                <c:pt idx="1">
                  <c:v>88.639892107202783</c:v>
                </c:pt>
                <c:pt idx="2">
                  <c:v>84.08110778302256</c:v>
                </c:pt>
                <c:pt idx="3">
                  <c:v>43.723242429469785</c:v>
                </c:pt>
                <c:pt idx="4">
                  <c:v>-5.208022958583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C3A-40C2-94A0-712AA3B10E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3623576"/>
        <c:axId val="513623248"/>
      </c:scatterChart>
      <c:valAx>
        <c:axId val="513623576"/>
        <c:scaling>
          <c:logBase val="10"/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/>
                  <a:t>[Propranolol] </a:t>
                </a:r>
                <a:r>
                  <a:rPr lang="el-GR" sz="800"/>
                  <a:t>μ</a:t>
                </a:r>
                <a:r>
                  <a:rPr lang="en-US" sz="800"/>
                  <a:t>M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3623248"/>
        <c:crosses val="autoZero"/>
        <c:crossBetween val="midCat"/>
      </c:valAx>
      <c:valAx>
        <c:axId val="51362324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dirty="0"/>
                  <a:t>% </a:t>
                </a:r>
                <a:r>
                  <a:rPr lang="en-US" sz="900" dirty="0" smtClean="0"/>
                  <a:t>Cell</a:t>
                </a:r>
                <a:r>
                  <a:rPr lang="en-US" sz="900" baseline="0" dirty="0" smtClean="0"/>
                  <a:t> Number</a:t>
                </a:r>
                <a:r>
                  <a:rPr lang="en-US" sz="900" dirty="0" smtClean="0"/>
                  <a:t> </a:t>
                </a:r>
                <a:r>
                  <a:rPr lang="en-US" sz="900" dirty="0"/>
                  <a:t>Relative to </a:t>
                </a:r>
                <a:r>
                  <a:rPr lang="en-US" sz="900" dirty="0" smtClean="0"/>
                  <a:t>Control</a:t>
                </a:r>
                <a:endParaRPr lang="en-US" sz="900" dirty="0"/>
              </a:p>
            </c:rich>
          </c:tx>
          <c:layout>
            <c:manualLayout>
              <c:xMode val="edge"/>
              <c:yMode val="edge"/>
              <c:x val="8.5391144403206498E-2"/>
              <c:y val="9.897445779005288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3623576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9706158986602607"/>
          <c:y val="9.3237311082690733E-2"/>
          <c:w val="0.60014564517863245"/>
          <c:h val="0.746474022477469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LM3 and mEERL High Dose Aten'!$F$1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MLM3 and mEERL High Dose Aten'!$F$8,'MLM3 and mEERL High Dose Aten'!$F$19)</c:f>
                <c:numCache>
                  <c:formatCode>General</c:formatCode>
                  <c:ptCount val="2"/>
                  <c:pt idx="0">
                    <c:v>1.3035705857167241</c:v>
                  </c:pt>
                  <c:pt idx="1">
                    <c:v>3.0573166523996873</c:v>
                  </c:pt>
                </c:numCache>
              </c:numRef>
            </c:plus>
            <c:minus>
              <c:numRef>
                <c:f>('MLM3 and mEERL High Dose Aten'!$F$8,'MLM3 and mEERL High Dose Aten'!$F$19)</c:f>
                <c:numCache>
                  <c:formatCode>General</c:formatCode>
                  <c:ptCount val="2"/>
                  <c:pt idx="0">
                    <c:v>1.3035705857167241</c:v>
                  </c:pt>
                  <c:pt idx="1">
                    <c:v>3.057316652399687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MLM3 and mEERL High Dose Aten'!$I$19:$J$19</c:f>
              <c:strCache>
                <c:ptCount val="2"/>
                <c:pt idx="0">
                  <c:v>MLM3</c:v>
                </c:pt>
                <c:pt idx="1">
                  <c:v>mEERL</c:v>
                </c:pt>
              </c:strCache>
            </c:strRef>
          </c:cat>
          <c:val>
            <c:numRef>
              <c:f>('MLM3 and mEERL High Dose Aten'!$F$7,'MLM3 and mEERL High Dose Aten'!$F$18)</c:f>
              <c:numCache>
                <c:formatCode>General</c:formatCode>
                <c:ptCount val="2"/>
                <c:pt idx="0">
                  <c:v>100.00000000000001</c:v>
                </c:pt>
                <c:pt idx="1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68-4603-9B0D-C340067C7E58}"/>
            </c:ext>
          </c:extLst>
        </c:ser>
        <c:ser>
          <c:idx val="1"/>
          <c:order val="1"/>
          <c:tx>
            <c:strRef>
              <c:f>'MLM3 and mEERL High Dose Aten'!$G$1</c:f>
              <c:strCache>
                <c:ptCount val="1"/>
                <c:pt idx="0">
                  <c:v>100μM Ate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Lbl>
              <c:idx val="0"/>
              <c:layout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4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400"/>
                      <a:t>*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400" b="0" i="0" u="none" strike="noStrike" kern="1200" baseline="0">
                      <a:solidFill>
                        <a:sysClr val="windowText" lastClr="00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7A68-4603-9B0D-C340067C7E58}"/>
                </c:ext>
              </c:extLst>
            </c:dLbl>
            <c:dLbl>
              <c:idx val="1"/>
              <c:layout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4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400"/>
                      <a:t>*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400" b="0" i="0" u="none" strike="noStrike" kern="1200" baseline="0">
                      <a:solidFill>
                        <a:sysClr val="windowText" lastClr="00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7A68-4603-9B0D-C340067C7E5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('MLM3 and mEERL High Dose Aten'!$G$8,'MLM3 and mEERL High Dose Aten'!$G$19)</c:f>
                <c:numCache>
                  <c:formatCode>General</c:formatCode>
                  <c:ptCount val="2"/>
                  <c:pt idx="0">
                    <c:v>1.6418133381094109</c:v>
                  </c:pt>
                  <c:pt idx="1">
                    <c:v>0.36912569673420359</c:v>
                  </c:pt>
                </c:numCache>
              </c:numRef>
            </c:plus>
            <c:minus>
              <c:numRef>
                <c:f>('MLM3 and mEERL High Dose Aten'!$G$8,'MLM3 and mEERL High Dose Aten'!$G$19)</c:f>
                <c:numCache>
                  <c:formatCode>General</c:formatCode>
                  <c:ptCount val="2"/>
                  <c:pt idx="0">
                    <c:v>1.6418133381094109</c:v>
                  </c:pt>
                  <c:pt idx="1">
                    <c:v>0.36912569673420359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MLM3 and mEERL High Dose Aten'!$I$19:$J$19</c:f>
              <c:strCache>
                <c:ptCount val="2"/>
                <c:pt idx="0">
                  <c:v>MLM3</c:v>
                </c:pt>
                <c:pt idx="1">
                  <c:v>mEERL</c:v>
                </c:pt>
              </c:strCache>
            </c:strRef>
          </c:cat>
          <c:val>
            <c:numRef>
              <c:f>('MLM3 and mEERL High Dose Aten'!$G$7,'MLM3 and mEERL High Dose Aten'!$G$18)</c:f>
              <c:numCache>
                <c:formatCode>General</c:formatCode>
                <c:ptCount val="2"/>
                <c:pt idx="0">
                  <c:v>89.946581196581192</c:v>
                </c:pt>
                <c:pt idx="1">
                  <c:v>86.9347083826911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A68-4603-9B0D-C340067C7E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9"/>
        <c:overlap val="-15"/>
        <c:axId val="563378704"/>
        <c:axId val="563379360"/>
      </c:barChart>
      <c:catAx>
        <c:axId val="563378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3379360"/>
        <c:crosses val="autoZero"/>
        <c:auto val="1"/>
        <c:lblAlgn val="ctr"/>
        <c:lblOffset val="100"/>
        <c:noMultiLvlLbl val="0"/>
      </c:catAx>
      <c:valAx>
        <c:axId val="56337936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% Cell Number</a:t>
                </a:r>
                <a:r>
                  <a:rPr lang="en-US" baseline="0" dirty="0" smtClean="0"/>
                  <a:t> Relative to Control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33787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837200886100937"/>
          <c:y val="4.2796877865862344E-3"/>
          <c:w val="0.26985465605100201"/>
          <c:h val="0.17013998250218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v>Control</c:v>
          </c:tx>
          <c:spPr>
            <a:ln>
              <a:solidFill>
                <a:schemeClr val="accent1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umor Volume'!$D$93:$H$93</c:f>
                <c:numCache>
                  <c:formatCode>General</c:formatCode>
                  <c:ptCount val="5"/>
                  <c:pt idx="0">
                    <c:v>8.8881937690010098</c:v>
                  </c:pt>
                  <c:pt idx="1">
                    <c:v>17.319385792291424</c:v>
                  </c:pt>
                  <c:pt idx="2">
                    <c:v>37.14587693265122</c:v>
                  </c:pt>
                  <c:pt idx="3">
                    <c:v>86.866017446446605</c:v>
                  </c:pt>
                  <c:pt idx="4">
                    <c:v>353.52514673295735</c:v>
                  </c:pt>
                </c:numCache>
              </c:numRef>
            </c:plus>
            <c:minus>
              <c:numRef>
                <c:f>'Tumor Volume'!$D$94:$H$94</c:f>
                <c:numCache>
                  <c:formatCode>General</c:formatCode>
                  <c:ptCount val="5"/>
                  <c:pt idx="0">
                    <c:v>4.7141137024895761</c:v>
                  </c:pt>
                  <c:pt idx="1">
                    <c:v>15.190798870112909</c:v>
                  </c:pt>
                  <c:pt idx="2">
                    <c:v>36.351157660978544</c:v>
                  </c:pt>
                  <c:pt idx="3">
                    <c:v>77.153327857115599</c:v>
                  </c:pt>
                  <c:pt idx="4">
                    <c:v>341.09313062745724</c:v>
                  </c:pt>
                </c:numCache>
              </c:numRef>
            </c:minus>
          </c:errBars>
          <c:cat>
            <c:numRef>
              <c:f>'Tumor Volume'!$D$73:$H$73</c:f>
              <c:numCache>
                <c:formatCode>General</c:formatCode>
                <c:ptCount val="5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  <c:pt idx="4">
                  <c:v>28</c:v>
                </c:pt>
              </c:numCache>
            </c:numRef>
          </c:cat>
          <c:val>
            <c:numRef>
              <c:f>'Tumor Volume'!$D$76:$H$76</c:f>
              <c:numCache>
                <c:formatCode>General</c:formatCode>
                <c:ptCount val="5"/>
                <c:pt idx="0">
                  <c:v>192.20355555555557</c:v>
                </c:pt>
                <c:pt idx="1">
                  <c:v>331.84966666666662</c:v>
                </c:pt>
                <c:pt idx="2">
                  <c:v>536.4091111111112</c:v>
                </c:pt>
                <c:pt idx="3">
                  <c:v>961.35293333333334</c:v>
                </c:pt>
                <c:pt idx="4">
                  <c:v>3302.44944444444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460-4B68-8EFE-BBC98B0448A7}"/>
            </c:ext>
          </c:extLst>
        </c:ser>
        <c:ser>
          <c:idx val="1"/>
          <c:order val="1"/>
          <c:tx>
            <c:v>Pro</c:v>
          </c:tx>
          <c:spPr>
            <a:ln>
              <a:solidFill>
                <a:schemeClr val="accent2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Tumor Volume'!$D$94:$H$94</c:f>
                <c:numCache>
                  <c:formatCode>General</c:formatCode>
                  <c:ptCount val="5"/>
                  <c:pt idx="0">
                    <c:v>4.7141137024895761</c:v>
                  </c:pt>
                  <c:pt idx="1">
                    <c:v>15.190798870112909</c:v>
                  </c:pt>
                  <c:pt idx="2">
                    <c:v>36.351157660978544</c:v>
                  </c:pt>
                  <c:pt idx="3">
                    <c:v>77.153327857115599</c:v>
                  </c:pt>
                  <c:pt idx="4">
                    <c:v>341.09313062745724</c:v>
                  </c:pt>
                </c:numCache>
              </c:numRef>
            </c:plus>
            <c:minus>
              <c:numRef>
                <c:f>'Tumor Volume'!$D$94:$H$94</c:f>
                <c:numCache>
                  <c:formatCode>General</c:formatCode>
                  <c:ptCount val="5"/>
                  <c:pt idx="0">
                    <c:v>4.7141137024895761</c:v>
                  </c:pt>
                  <c:pt idx="1">
                    <c:v>15.190798870112909</c:v>
                  </c:pt>
                  <c:pt idx="2">
                    <c:v>36.351157660978544</c:v>
                  </c:pt>
                  <c:pt idx="3">
                    <c:v>77.153327857115599</c:v>
                  </c:pt>
                  <c:pt idx="4">
                    <c:v>341.09313062745724</c:v>
                  </c:pt>
                </c:numCache>
              </c:numRef>
            </c:minus>
          </c:errBars>
          <c:cat>
            <c:numRef>
              <c:f>'Tumor Volume'!$D$73:$H$73</c:f>
              <c:numCache>
                <c:formatCode>General</c:formatCode>
                <c:ptCount val="5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  <c:pt idx="4">
                  <c:v>28</c:v>
                </c:pt>
              </c:numCache>
            </c:numRef>
          </c:cat>
          <c:val>
            <c:numRef>
              <c:f>'Tumor Volume'!$D$77:$H$77</c:f>
              <c:numCache>
                <c:formatCode>General</c:formatCode>
                <c:ptCount val="5"/>
                <c:pt idx="0">
                  <c:v>200.57799999999997</c:v>
                </c:pt>
                <c:pt idx="1">
                  <c:v>300.11129999999997</c:v>
                </c:pt>
                <c:pt idx="2">
                  <c:v>511.3336000000001</c:v>
                </c:pt>
                <c:pt idx="3">
                  <c:v>967.16367329999991</c:v>
                </c:pt>
                <c:pt idx="4">
                  <c:v>3355.29520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460-4B68-8EFE-BBC98B0448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6175744"/>
        <c:axId val="156181632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v>MLM3 Control</c:v>
                </c:tx>
                <c:spPr>
                  <a:ln>
                    <a:solidFill>
                      <a:schemeClr val="tx1"/>
                    </a:solidFill>
                    <a:prstDash val="solid"/>
                  </a:ln>
                </c:spPr>
                <c:marker>
                  <c:symbol val="none"/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Tumor Volume'!$D$95:$G$9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6.9232409948102225</c:v>
                        </c:pt>
                        <c:pt idx="1">
                          <c:v>34.621518085979062</c:v>
                        </c:pt>
                        <c:pt idx="2">
                          <c:v>164.73007009059864</c:v>
                        </c:pt>
                        <c:pt idx="3">
                          <c:v>277.45005235896451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Tumor Volume'!$D$95:$G$95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6.9232409948102225</c:v>
                        </c:pt>
                        <c:pt idx="1">
                          <c:v>34.621518085979062</c:v>
                        </c:pt>
                        <c:pt idx="2">
                          <c:v>164.73007009059864</c:v>
                        </c:pt>
                        <c:pt idx="3">
                          <c:v>277.45005235896451</c:v>
                        </c:pt>
                      </c:numCache>
                    </c:numRef>
                  </c:minus>
                </c:errBars>
                <c:cat>
                  <c:numRef>
                    <c:extLst>
                      <c:ext uri="{02D57815-91ED-43cb-92C2-25804820EDAC}">
                        <c15:formulaRef>
                          <c15:sqref>'Tumor Volume'!$D$73:$H$73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7</c:v>
                      </c:pt>
                      <c:pt idx="2">
                        <c:v>14</c:v>
                      </c:pt>
                      <c:pt idx="3">
                        <c:v>21</c:v>
                      </c:pt>
                      <c:pt idx="4">
                        <c:v>28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Tumor Volume'!$D$78:$G$78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204.82050000000004</c:v>
                      </c:pt>
                      <c:pt idx="1">
                        <c:v>603.11700000000008</c:v>
                      </c:pt>
                      <c:pt idx="2">
                        <c:v>1733.5489460000001</c:v>
                      </c:pt>
                      <c:pt idx="3">
                        <c:v>3432.0116251999998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2-0460-4B68-8EFE-BBC98B0448A7}"/>
                  </c:ext>
                </c:extLst>
              </c15:ser>
            </c15:filteredLineSeries>
            <c15:filteredLineSeries>
              <c15:ser>
                <c:idx val="3"/>
                <c:order val="3"/>
                <c:tx>
                  <c:v>MLM3 Propranolol</c:v>
                </c:tx>
                <c:spPr>
                  <a:ln>
                    <a:solidFill>
                      <a:schemeClr val="tx1"/>
                    </a:solidFill>
                    <a:prstDash val="dash"/>
                  </a:ln>
                </c:spPr>
                <c:marker>
                  <c:symbol val="none"/>
                </c:marker>
                <c:dLbls>
                  <c:dLbl>
                    <c:idx val="0"/>
                    <c:delete val="1"/>
                    <c:extLst xmlns:c15="http://schemas.microsoft.com/office/drawing/2012/chart">
                      <c:ext xmlns:c15="http://schemas.microsoft.com/office/drawing/2012/chart" uri="{CE6537A1-D6FC-4f65-9D91-7224C49458BB}"/>
                      <c:ext xmlns:c16="http://schemas.microsoft.com/office/drawing/2014/chart" uri="{C3380CC4-5D6E-409C-BE32-E72D297353CC}">
                        <c16:uniqueId val="{00000003-0460-4B68-8EFE-BBC98B0448A7}"/>
                      </c:ext>
                    </c:extLst>
                  </c:dLbl>
                  <c:dLbl>
                    <c:idx val="1"/>
                    <c:delete val="1"/>
                    <c:extLst xmlns:c15="http://schemas.microsoft.com/office/drawing/2012/chart">
                      <c:ext xmlns:c15="http://schemas.microsoft.com/office/drawing/2012/chart" uri="{CE6537A1-D6FC-4f65-9D91-7224C49458BB}"/>
                      <c:ext xmlns:c16="http://schemas.microsoft.com/office/drawing/2014/chart" uri="{C3380CC4-5D6E-409C-BE32-E72D297353CC}">
                        <c16:uniqueId val="{00000004-0460-4B68-8EFE-BBC98B0448A7}"/>
                      </c:ext>
                    </c:extLst>
                  </c:dLbl>
                  <c:dLbl>
                    <c:idx val="2"/>
                    <c:delete val="1"/>
                    <c:extLst xmlns:c15="http://schemas.microsoft.com/office/drawing/2012/chart">
                      <c:ext xmlns:c15="http://schemas.microsoft.com/office/drawing/2012/chart" uri="{CE6537A1-D6FC-4f65-9D91-7224C49458BB}"/>
                      <c:ext xmlns:c16="http://schemas.microsoft.com/office/drawing/2014/chart" uri="{C3380CC4-5D6E-409C-BE32-E72D297353CC}">
                        <c16:uniqueId val="{00000005-0460-4B68-8EFE-BBC98B0448A7}"/>
                      </c:ext>
                    </c:extLst>
                  </c:dLbl>
                  <c:dLbl>
                    <c:idx val="3"/>
                    <c:layout>
                      <c:manualLayout>
                        <c:x val="-1.1111111111111112E-2"/>
                        <c:y val="4.6292650918635173E-3"/>
                      </c:manualLayout>
                    </c:layout>
                    <c:tx>
                      <c:rich>
                        <a:bodyPr/>
                        <a:lstStyle/>
                        <a:p>
                          <a:r>
                            <a:rPr lang="en-US" sz="1400" b="1"/>
                            <a:t>*</a:t>
                          </a:r>
                        </a:p>
                      </c:rich>
                    </c:tx>
                    <c:showLegendKey val="0"/>
                    <c:showVal val="1"/>
                    <c:showCatName val="0"/>
                    <c:showSerName val="0"/>
                    <c:showPercent val="0"/>
                    <c:showBubbleSize val="0"/>
                    <c:extLst xmlns:c15="http://schemas.microsoft.com/office/drawing/2012/chart">
                      <c:ext xmlns:c15="http://schemas.microsoft.com/office/drawing/2012/chart" uri="{CE6537A1-D6FC-4f65-9D91-7224C49458BB}"/>
                      <c:ext xmlns:c16="http://schemas.microsoft.com/office/drawing/2014/chart" uri="{C3380CC4-5D6E-409C-BE32-E72D297353CC}">
                        <c16:uniqueId val="{00000006-0460-4B68-8EFE-BBC98B0448A7}"/>
                      </c:ext>
                    </c:extLst>
                  </c:dLbl>
                  <c:spPr>
                    <a:noFill/>
                    <a:ln>
                      <a:noFill/>
                    </a:ln>
                    <a:effectLst/>
                  </c:spPr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 xmlns:c15="http://schemas.microsoft.com/office/drawing/2012/chart">
                    <c:ext xmlns:c15="http://schemas.microsoft.com/office/drawing/2012/chart" uri="{CE6537A1-D6FC-4f65-9D91-7224C49458BB}">
                      <c15:showLeaderLines val="0"/>
                    </c:ext>
                  </c:extLst>
                </c:dLbls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Tumor Volume'!$D$96:$G$96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5.4891975277711467</c:v>
                        </c:pt>
                        <c:pt idx="1">
                          <c:v>41.348420295513641</c:v>
                        </c:pt>
                        <c:pt idx="2">
                          <c:v>113.39697418516531</c:v>
                        </c:pt>
                        <c:pt idx="3">
                          <c:v>193.90438826403337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'Tumor Volume'!$D$96:$G$96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5.4891975277711467</c:v>
                        </c:pt>
                        <c:pt idx="1">
                          <c:v>41.348420295513641</c:v>
                        </c:pt>
                        <c:pt idx="2">
                          <c:v>113.39697418516531</c:v>
                        </c:pt>
                        <c:pt idx="3">
                          <c:v>193.90438826403337</c:v>
                        </c:pt>
                      </c:numCache>
                    </c:numRef>
                  </c:minus>
                </c:errBars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umor Volume'!$D$73:$H$73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7</c:v>
                      </c:pt>
                      <c:pt idx="2">
                        <c:v>14</c:v>
                      </c:pt>
                      <c:pt idx="3">
                        <c:v>21</c:v>
                      </c:pt>
                      <c:pt idx="4">
                        <c:v>28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umor Volume'!$D$79:$G$79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80.21510000000004</c:v>
                      </c:pt>
                      <c:pt idx="1">
                        <c:v>456.24529999999993</c:v>
                      </c:pt>
                      <c:pt idx="2">
                        <c:v>1308.5052000000001</c:v>
                      </c:pt>
                      <c:pt idx="3">
                        <c:v>2427.3361833999998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0460-4B68-8EFE-BBC98B0448A7}"/>
                  </c:ext>
                </c:extLst>
              </c15:ser>
            </c15:filteredLineSeries>
          </c:ext>
        </c:extLst>
      </c:lineChart>
      <c:catAx>
        <c:axId val="15617574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56181632"/>
        <c:crosses val="autoZero"/>
        <c:auto val="1"/>
        <c:lblAlgn val="ctr"/>
        <c:lblOffset val="100"/>
        <c:noMultiLvlLbl val="0"/>
      </c:catAx>
      <c:valAx>
        <c:axId val="1561816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Tumor Volume (mm</a:t>
                </a:r>
                <a:r>
                  <a:rPr lang="en-US" baseline="30000"/>
                  <a:t>3</a:t>
                </a:r>
                <a:r>
                  <a:rPr lang="en-US" baseline="0"/>
                  <a:t>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5617574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071399463022883"/>
          <c:y val="0.2742091848345547"/>
          <c:w val="0.22928600536977123"/>
          <c:h val="0.22407870981445235"/>
        </c:manualLayout>
      </c:layout>
      <c:overlay val="0"/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7205314960629922"/>
          <c:y val="5.0925925925925923E-2"/>
          <c:w val="0.79739129483814519"/>
          <c:h val="0.7301924759405074"/>
        </c:manualLayout>
      </c:layout>
      <c:lineChart>
        <c:grouping val="standard"/>
        <c:varyColors val="0"/>
        <c:ser>
          <c:idx val="0"/>
          <c:order val="0"/>
          <c:tx>
            <c:v>CRT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CRT and CRTPro Body Weight'!$C$21:$J$2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39720004850535207</c:v>
                  </c:pt>
                  <c:pt idx="2">
                    <c:v>0.88962172444476584</c:v>
                  </c:pt>
                  <c:pt idx="3">
                    <c:v>0.63877686096023434</c:v>
                  </c:pt>
                  <c:pt idx="4">
                    <c:v>0.74686304948751614</c:v>
                  </c:pt>
                  <c:pt idx="5">
                    <c:v>0.75433942168221624</c:v>
                  </c:pt>
                  <c:pt idx="6">
                    <c:v>0.71138708558830921</c:v>
                  </c:pt>
                  <c:pt idx="7">
                    <c:v>0.86533804933836656</c:v>
                  </c:pt>
                </c:numCache>
              </c:numRef>
            </c:plus>
            <c:minus>
              <c:numRef>
                <c:f>'CRT and CRTPro Body Weight'!$C$21:$J$2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39720004850535207</c:v>
                  </c:pt>
                  <c:pt idx="2">
                    <c:v>0.88962172444476584</c:v>
                  </c:pt>
                  <c:pt idx="3">
                    <c:v>0.63877686096023434</c:v>
                  </c:pt>
                  <c:pt idx="4">
                    <c:v>0.74686304948751614</c:v>
                  </c:pt>
                  <c:pt idx="5">
                    <c:v>0.75433942168221624</c:v>
                  </c:pt>
                  <c:pt idx="6">
                    <c:v>0.71138708558830921</c:v>
                  </c:pt>
                  <c:pt idx="7">
                    <c:v>0.865338049338366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CRT and CRTPro Body Weight'!$C$1:$H$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  <c:pt idx="4">
                  <c:v>28</c:v>
                </c:pt>
                <c:pt idx="5">
                  <c:v>35</c:v>
                </c:pt>
              </c:numCache>
            </c:numRef>
          </c:cat>
          <c:val>
            <c:numRef>
              <c:f>'CRT and CRTPro Body Weight'!$C$20:$H$20</c:f>
              <c:numCache>
                <c:formatCode>General</c:formatCode>
                <c:ptCount val="6"/>
                <c:pt idx="0">
                  <c:v>100</c:v>
                </c:pt>
                <c:pt idx="1">
                  <c:v>98.258356859485573</c:v>
                </c:pt>
                <c:pt idx="2">
                  <c:v>96.407236412690722</c:v>
                </c:pt>
                <c:pt idx="3">
                  <c:v>96.398518562495553</c:v>
                </c:pt>
                <c:pt idx="4">
                  <c:v>101.65157849167893</c:v>
                </c:pt>
                <c:pt idx="5">
                  <c:v>105.027927956740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886-4390-BB36-B71BE5626DE4}"/>
            </c:ext>
          </c:extLst>
        </c:ser>
        <c:ser>
          <c:idx val="1"/>
          <c:order val="1"/>
          <c:tx>
            <c:v>CRT+Pro</c:v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CRT and CRTPro Body Weight'!$C$38:$J$3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41289129251373169</c:v>
                  </c:pt>
                  <c:pt idx="2">
                    <c:v>0.68088495741096755</c:v>
                  </c:pt>
                  <c:pt idx="3">
                    <c:v>0.75204186755107338</c:v>
                  </c:pt>
                  <c:pt idx="4">
                    <c:v>1.1435155752597559</c:v>
                  </c:pt>
                  <c:pt idx="5">
                    <c:v>1.8617591790971273</c:v>
                  </c:pt>
                  <c:pt idx="6">
                    <c:v>2.0104936291885549</c:v>
                  </c:pt>
                  <c:pt idx="7">
                    <c:v>2.1394280941538715</c:v>
                  </c:pt>
                </c:numCache>
              </c:numRef>
            </c:plus>
            <c:minus>
              <c:numRef>
                <c:f>'CRT and CRTPro Body Weight'!$C$38:$J$3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41289129251373169</c:v>
                  </c:pt>
                  <c:pt idx="2">
                    <c:v>0.68088495741096755</c:v>
                  </c:pt>
                  <c:pt idx="3">
                    <c:v>0.75204186755107338</c:v>
                  </c:pt>
                  <c:pt idx="4">
                    <c:v>1.1435155752597559</c:v>
                  </c:pt>
                  <c:pt idx="5">
                    <c:v>1.8617591790971273</c:v>
                  </c:pt>
                  <c:pt idx="6">
                    <c:v>2.0104936291885549</c:v>
                  </c:pt>
                  <c:pt idx="7">
                    <c:v>2.13942809415387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CRT and CRTPro Body Weight'!$C$1:$H$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  <c:pt idx="4">
                  <c:v>28</c:v>
                </c:pt>
                <c:pt idx="5">
                  <c:v>35</c:v>
                </c:pt>
              </c:numCache>
            </c:numRef>
          </c:cat>
          <c:val>
            <c:numRef>
              <c:f>'CRT and CRTPro Body Weight'!$C$37:$H$37</c:f>
              <c:numCache>
                <c:formatCode>General</c:formatCode>
                <c:ptCount val="6"/>
                <c:pt idx="0">
                  <c:v>100</c:v>
                </c:pt>
                <c:pt idx="1">
                  <c:v>97.847228113236682</c:v>
                </c:pt>
                <c:pt idx="2">
                  <c:v>97.58463201220907</c:v>
                </c:pt>
                <c:pt idx="3">
                  <c:v>97.607946220837874</c:v>
                </c:pt>
                <c:pt idx="4">
                  <c:v>103.71813518490632</c:v>
                </c:pt>
                <c:pt idx="5">
                  <c:v>107.921611437079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886-4390-BB36-B71BE5626D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1458448"/>
        <c:axId val="641452216"/>
      </c:lineChart>
      <c:catAx>
        <c:axId val="641458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s Post-Tumor</a:t>
                </a:r>
                <a:r>
                  <a:rPr lang="en-US" baseline="0"/>
                  <a:t> Implantation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1452216"/>
        <c:crosses val="autoZero"/>
        <c:auto val="1"/>
        <c:lblAlgn val="ctr"/>
        <c:lblOffset val="100"/>
        <c:noMultiLvlLbl val="0"/>
      </c:catAx>
      <c:valAx>
        <c:axId val="6414522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Change in Body Mass Relative to Baseiln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14584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474125109361332"/>
          <c:y val="4.6874453193350825E-2"/>
          <c:w val="0.1771839457567804"/>
          <c:h val="0.1244218431029454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36DEDD-0CE8-40FF-8171-3EA26375A323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C24566-BC93-4543-8EDC-798F99115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3694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l Figure 1:</a:t>
            </a:r>
            <a:r>
              <a:rPr lang="en-US" baseline="0" dirty="0" smtClean="0"/>
              <a:t> Daily propranolol does not affect parental </a:t>
            </a:r>
            <a:r>
              <a:rPr lang="en-US" baseline="0" dirty="0" err="1" smtClean="0"/>
              <a:t>mEERL</a:t>
            </a:r>
            <a:r>
              <a:rPr lang="en-US" baseline="0" dirty="0" smtClean="0"/>
              <a:t> tumor growth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488394-7330-4D4F-8092-9404C0E3430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5948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l</a:t>
            </a:r>
            <a:r>
              <a:rPr lang="en-US" baseline="0" dirty="0" smtClean="0"/>
              <a:t> Figure 2: </a:t>
            </a:r>
            <a:r>
              <a:rPr lang="en-US" sz="1200" b="0" baseline="0" dirty="0" smtClean="0"/>
              <a:t>Screening of </a:t>
            </a:r>
            <a:r>
              <a:rPr lang="el-GR" sz="1200" b="0" dirty="0" smtClean="0"/>
              <a:t>β</a:t>
            </a:r>
            <a:r>
              <a:rPr lang="en-US" sz="1200" b="0" baseline="0" dirty="0" smtClean="0"/>
              <a:t>2</a:t>
            </a:r>
            <a:r>
              <a:rPr lang="en-US" sz="1200" b="0" dirty="0" smtClean="0"/>
              <a:t>AR CRISPR clones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488394-7330-4D4F-8092-9404C0E3430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662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602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973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149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942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099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700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023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3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324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884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434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E06DE-1141-49A0-8DB7-FDF76737A616}" type="datetimeFigureOut">
              <a:rPr lang="en-US" smtClean="0"/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875D9-0930-4AB6-B578-985EC19A01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937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chart" Target="../charts/chart2.xml"/><Relationship Id="rId7" Type="http://schemas.openxmlformats.org/officeDocument/2006/relationships/image" Target="../media/image2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1.png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10.pn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11.png"/><Relationship Id="rId4" Type="http://schemas.microsoft.com/office/2007/relationships/hdphoto" Target="../media/hdphoto2.wdp"/><Relationship Id="rId9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tif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microsoft.com/office/2007/relationships/hdphoto" Target="../media/hdphoto6.wdp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6151384" y="2519222"/>
            <a:ext cx="2912016" cy="2932714"/>
            <a:chOff x="0" y="0"/>
            <a:chExt cx="2468880" cy="2667000"/>
          </a:xfrm>
        </p:grpSpPr>
        <p:graphicFrame>
          <p:nvGraphicFramePr>
            <p:cNvPr id="9" name="Chart 8"/>
            <p:cNvGraphicFramePr/>
            <p:nvPr>
              <p:extLst>
                <p:ext uri="{D42A27DB-BD31-4B8C-83A1-F6EECF244321}">
                  <p14:modId xmlns:p14="http://schemas.microsoft.com/office/powerpoint/2010/main" val="3216460386"/>
                </p:ext>
              </p:extLst>
            </p:nvPr>
          </p:nvGraphicFramePr>
          <p:xfrm>
            <a:off x="0" y="0"/>
            <a:ext cx="2468880" cy="2667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10" name="Straight Connector 9"/>
            <p:cNvCxnSpPr/>
            <p:nvPr/>
          </p:nvCxnSpPr>
          <p:spPr>
            <a:xfrm>
              <a:off x="1132406" y="457916"/>
              <a:ext cx="81280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1" name="TextBox 6"/>
            <p:cNvSpPr txBox="1"/>
            <p:nvPr/>
          </p:nvSpPr>
          <p:spPr>
            <a:xfrm>
              <a:off x="1081606" y="179070"/>
              <a:ext cx="914400" cy="215900"/>
            </a:xfrm>
            <a:prstGeom prst="rect">
              <a:avLst/>
            </a:prstGeom>
            <a:solidFill>
              <a:sysClr val="window" lastClr="FFFFFF"/>
            </a:solidFill>
            <a:ln w="9525" cmpd="sng">
              <a:noFill/>
            </a:ln>
            <a:effectLst/>
          </p:spPr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ns</a:t>
              </a:r>
            </a:p>
          </p:txBody>
        </p:sp>
      </p:grp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8760857"/>
              </p:ext>
            </p:extLst>
          </p:nvPr>
        </p:nvGraphicFramePr>
        <p:xfrm>
          <a:off x="7156014" y="117973"/>
          <a:ext cx="3037246" cy="2317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1428752"/>
              </p:ext>
            </p:extLst>
          </p:nvPr>
        </p:nvGraphicFramePr>
        <p:xfrm>
          <a:off x="4150080" y="259803"/>
          <a:ext cx="3181536" cy="2335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2250741" y="5380816"/>
            <a:ext cx="81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/>
              <a:t>mEERL</a:t>
            </a:r>
            <a:endParaRPr 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3492568" y="5380816"/>
            <a:ext cx="8126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MLM3</a:t>
            </a:r>
            <a:endParaRPr lang="en-US" sz="1400" dirty="0"/>
          </a:p>
        </p:txBody>
      </p:sp>
      <p:grpSp>
        <p:nvGrpSpPr>
          <p:cNvPr id="25" name="Group 24"/>
          <p:cNvGrpSpPr/>
          <p:nvPr/>
        </p:nvGrpSpPr>
        <p:grpSpPr>
          <a:xfrm>
            <a:off x="1981201" y="2681288"/>
            <a:ext cx="2570572" cy="2432300"/>
            <a:chOff x="3966692" y="862873"/>
            <a:chExt cx="3575292" cy="3796213"/>
          </a:xfrm>
        </p:grpSpPr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24" t="25656" r="58536" b="63920"/>
            <a:stretch/>
          </p:blipFill>
          <p:spPr>
            <a:xfrm flipH="1">
              <a:off x="3966692" y="4111125"/>
              <a:ext cx="3575292" cy="5479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7"/>
            <a:srcRect l="15151" t="16284" r="12179" b="16743"/>
            <a:stretch/>
          </p:blipFill>
          <p:spPr>
            <a:xfrm flipH="1">
              <a:off x="3966692" y="862873"/>
              <a:ext cx="3575290" cy="28988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6" name="TextBox 25"/>
          <p:cNvSpPr txBox="1"/>
          <p:nvPr/>
        </p:nvSpPr>
        <p:spPr>
          <a:xfrm>
            <a:off x="4615225" y="5174937"/>
            <a:ext cx="1704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[Propranolol] (</a:t>
            </a:r>
            <a:r>
              <a:rPr lang="el-GR" sz="1200" dirty="0" smtClean="0">
                <a:latin typeface="Calibri" panose="020F0502020204030204" pitchFamily="34" charset="0"/>
              </a:rPr>
              <a:t>μ</a:t>
            </a:r>
            <a:r>
              <a:rPr lang="en-US" sz="1200" dirty="0" smtClean="0">
                <a:latin typeface="Calibri" panose="020F0502020204030204" pitchFamily="34" charset="0"/>
              </a:rPr>
              <a:t>M)</a:t>
            </a:r>
            <a:r>
              <a:rPr lang="en-US" sz="1200" dirty="0" smtClean="0"/>
              <a:t> 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4615225" y="4808242"/>
            <a:ext cx="1488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 smtClean="0">
                <a:latin typeface="Calibri" panose="020F0502020204030204" pitchFamily="34" charset="0"/>
              </a:rPr>
              <a:t>β</a:t>
            </a:r>
            <a:r>
              <a:rPr lang="en-US" sz="1200" dirty="0" smtClean="0">
                <a:latin typeface="Calibri" panose="020F0502020204030204" pitchFamily="34" charset="0"/>
              </a:rPr>
              <a:t>-actin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4615225" y="3521829"/>
            <a:ext cx="14885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Phospho</a:t>
            </a:r>
            <a:r>
              <a:rPr lang="en-US" sz="1200" dirty="0" smtClean="0"/>
              <a:t>-PKA</a:t>
            </a:r>
          </a:p>
          <a:p>
            <a:r>
              <a:rPr lang="en-US" sz="1200" dirty="0" smtClean="0"/>
              <a:t>Substrate </a:t>
            </a:r>
            <a:endParaRPr lang="en-US" sz="1200" dirty="0"/>
          </a:p>
        </p:txBody>
      </p:sp>
      <p:graphicFrame>
        <p:nvGraphicFramePr>
          <p:cNvPr id="31" name="Table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8464933"/>
              </p:ext>
            </p:extLst>
          </p:nvPr>
        </p:nvGraphicFramePr>
        <p:xfrm>
          <a:off x="1871320" y="5200873"/>
          <a:ext cx="2743905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6448">
                  <a:extLst>
                    <a:ext uri="{9D8B030D-6E8A-4147-A177-3AD203B41FA5}">
                      <a16:colId xmlns:a16="http://schemas.microsoft.com/office/drawing/2014/main" val="701406280"/>
                    </a:ext>
                  </a:extLst>
                </a:gridCol>
                <a:gridCol w="326995">
                  <a:extLst>
                    <a:ext uri="{9D8B030D-6E8A-4147-A177-3AD203B41FA5}">
                      <a16:colId xmlns:a16="http://schemas.microsoft.com/office/drawing/2014/main" val="2064702143"/>
                    </a:ext>
                  </a:extLst>
                </a:gridCol>
                <a:gridCol w="324782">
                  <a:extLst>
                    <a:ext uri="{9D8B030D-6E8A-4147-A177-3AD203B41FA5}">
                      <a16:colId xmlns:a16="http://schemas.microsoft.com/office/drawing/2014/main" val="2106271026"/>
                    </a:ext>
                  </a:extLst>
                </a:gridCol>
                <a:gridCol w="373794">
                  <a:extLst>
                    <a:ext uri="{9D8B030D-6E8A-4147-A177-3AD203B41FA5}">
                      <a16:colId xmlns:a16="http://schemas.microsoft.com/office/drawing/2014/main" val="1050204265"/>
                    </a:ext>
                  </a:extLst>
                </a:gridCol>
                <a:gridCol w="302924">
                  <a:extLst>
                    <a:ext uri="{9D8B030D-6E8A-4147-A177-3AD203B41FA5}">
                      <a16:colId xmlns:a16="http://schemas.microsoft.com/office/drawing/2014/main" val="2963701202"/>
                    </a:ext>
                  </a:extLst>
                </a:gridCol>
                <a:gridCol w="292795">
                  <a:extLst>
                    <a:ext uri="{9D8B030D-6E8A-4147-A177-3AD203B41FA5}">
                      <a16:colId xmlns:a16="http://schemas.microsoft.com/office/drawing/2014/main" val="2844197023"/>
                    </a:ext>
                  </a:extLst>
                </a:gridCol>
                <a:gridCol w="328950">
                  <a:extLst>
                    <a:ext uri="{9D8B030D-6E8A-4147-A177-3AD203B41FA5}">
                      <a16:colId xmlns:a16="http://schemas.microsoft.com/office/drawing/2014/main" val="219238726"/>
                    </a:ext>
                  </a:extLst>
                </a:gridCol>
                <a:gridCol w="407217">
                  <a:extLst>
                    <a:ext uri="{9D8B030D-6E8A-4147-A177-3AD203B41FA5}">
                      <a16:colId xmlns:a16="http://schemas.microsoft.com/office/drawing/2014/main" val="77601081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9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9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</a:rPr>
                        <a:t> 20</a:t>
                      </a:r>
                      <a:endParaRPr lang="en-US" sz="9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</a:rPr>
                        <a:t>100</a:t>
                      </a:r>
                      <a:endParaRPr lang="en-US" sz="9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en-US" sz="9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9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en-US" sz="9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dirty="0" smtClean="0">
                          <a:solidFill>
                            <a:schemeClr val="tx1"/>
                          </a:solidFill>
                        </a:rPr>
                        <a:t>100</a:t>
                      </a:r>
                      <a:endParaRPr lang="en-US" sz="9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6200446"/>
                  </a:ext>
                </a:extLst>
              </a:tr>
            </a:tbl>
          </a:graphicData>
        </a:graphic>
      </p:graphicFrame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3037567"/>
              </p:ext>
            </p:extLst>
          </p:nvPr>
        </p:nvGraphicFramePr>
        <p:xfrm>
          <a:off x="1493520" y="117973"/>
          <a:ext cx="2948261" cy="24012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222408" y="22993"/>
            <a:ext cx="542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4278773" y="22993"/>
            <a:ext cx="542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6884903" y="22993"/>
            <a:ext cx="542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1222407" y="2523790"/>
            <a:ext cx="542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6061245" y="2523790"/>
            <a:ext cx="542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E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40510" y="5662282"/>
            <a:ext cx="1164147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: </a:t>
            </a:r>
            <a:r>
              <a:rPr lang="el-G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drenergic blockade displays anti-tumor activity in HNSCC.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Results of an additional MTT assay treating 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ERL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r MLM3 cells with  a higher concentration of atenolol (100µM) for 48 hours, indicating a slight (but statistically significant) decrease in cell number (*p &lt; 0.05 compared to control).  Columns represent mean +/- SEM from four independent biological replicates; p-value reflects results of Mann Whitney test.  (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Dose response curve depicting leftward shift in propranolol IC</a:t>
            </a:r>
            <a:r>
              <a:rPr lang="en-US" sz="10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MLM3 versus 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ERL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.  Cells were treated with indicated concentration of propranolol for 96 hours.  Y-axis represents relative cell number as determined by MTT assay. Data points represent mean +/- SEM of 6 independent biological replicates.  (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MTT assay results of SCC cell lines treated with 40µM atenolol (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selective) or ICI-118,551 (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selective) for 64 hours (*p &lt; 0.05 compared to control; **p ≤ 0.004 compared to control).  HPV-status of SCC lines is listed below.  Columns represent mean +/- SEM from independent biological replicates (n = 10 [control] or 5 [atenolol and ICI-118,551]).  (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stern blot showing levels of phosphorylated PKA substrate in </a:t>
            </a:r>
            <a:r>
              <a:rPr 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ERL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left) and MLM3 cells (right) following 24-hour treatment with indicated concentrations of propranolol.  (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Results of a cell counting experiment treating primary human tonsil epithelial cells with 40</a:t>
            </a:r>
            <a:r>
              <a:rPr lang="el-G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 propranolol for 48 hours (ns = not significant).  Columns represent mean +/- SEM for independent biological replicates (n = 4).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2" name="Table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2390432"/>
              </p:ext>
            </p:extLst>
          </p:nvPr>
        </p:nvGraphicFramePr>
        <p:xfrm>
          <a:off x="7674427" y="2296136"/>
          <a:ext cx="1981320" cy="3962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660440">
                  <a:extLst>
                    <a:ext uri="{9D8B030D-6E8A-4147-A177-3AD203B41FA5}">
                      <a16:colId xmlns:a16="http://schemas.microsoft.com/office/drawing/2014/main" val="725489506"/>
                    </a:ext>
                  </a:extLst>
                </a:gridCol>
                <a:gridCol w="660440">
                  <a:extLst>
                    <a:ext uri="{9D8B030D-6E8A-4147-A177-3AD203B41FA5}">
                      <a16:colId xmlns:a16="http://schemas.microsoft.com/office/drawing/2014/main" val="2923697723"/>
                    </a:ext>
                  </a:extLst>
                </a:gridCol>
                <a:gridCol w="660440">
                  <a:extLst>
                    <a:ext uri="{9D8B030D-6E8A-4147-A177-3AD203B41FA5}">
                      <a16:colId xmlns:a16="http://schemas.microsoft.com/office/drawing/2014/main" val="123258783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 smtClean="0">
                          <a:solidFill>
                            <a:schemeClr val="tx1"/>
                          </a:solidFill>
                        </a:rPr>
                        <a:t>     HPV(-)</a:t>
                      </a:r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chemeClr val="tx1"/>
                          </a:solidFill>
                        </a:rPr>
                        <a:t>    HPV(-)</a:t>
                      </a:r>
                    </a:p>
                    <a:p>
                      <a:pPr algn="ctr"/>
                      <a:endParaRPr lang="en-US" sz="10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 smtClean="0">
                          <a:solidFill>
                            <a:schemeClr val="tx1"/>
                          </a:solidFill>
                        </a:rPr>
                        <a:t>  HPV(+)</a:t>
                      </a:r>
                    </a:p>
                    <a:p>
                      <a:pPr algn="ctr"/>
                      <a:endParaRPr lang="en-US" sz="10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1992928"/>
                  </a:ext>
                </a:extLst>
              </a:tr>
            </a:tbl>
          </a:graphicData>
        </a:graphic>
      </p:graphicFrame>
      <p:cxnSp>
        <p:nvCxnSpPr>
          <p:cNvPr id="5" name="Straight Connector 4"/>
          <p:cNvCxnSpPr/>
          <p:nvPr/>
        </p:nvCxnSpPr>
        <p:spPr>
          <a:xfrm flipH="1" flipV="1">
            <a:off x="1739616" y="3359374"/>
            <a:ext cx="233020" cy="28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 flipV="1">
            <a:off x="1739616" y="3572577"/>
            <a:ext cx="233020" cy="28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flipH="1" flipV="1">
            <a:off x="1739616" y="3782810"/>
            <a:ext cx="233020" cy="28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H="1" flipV="1">
            <a:off x="1739616" y="4041815"/>
            <a:ext cx="233020" cy="28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H="1" flipV="1">
            <a:off x="1739616" y="3196968"/>
            <a:ext cx="233020" cy="28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flipH="1" flipV="1">
            <a:off x="1739616" y="3033227"/>
            <a:ext cx="233020" cy="28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H="1" flipV="1">
            <a:off x="1739616" y="2899626"/>
            <a:ext cx="233020" cy="28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191099" y="3251652"/>
            <a:ext cx="604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/>
              <a:t>72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  <p:sp>
        <p:nvSpPr>
          <p:cNvPr id="40" name="TextBox 39"/>
          <p:cNvSpPr txBox="1"/>
          <p:nvPr/>
        </p:nvSpPr>
        <p:spPr>
          <a:xfrm>
            <a:off x="1191099" y="3461885"/>
            <a:ext cx="604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/>
              <a:t>55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  <p:sp>
        <p:nvSpPr>
          <p:cNvPr id="41" name="TextBox 40"/>
          <p:cNvSpPr txBox="1"/>
          <p:nvPr/>
        </p:nvSpPr>
        <p:spPr>
          <a:xfrm>
            <a:off x="1191099" y="3666003"/>
            <a:ext cx="604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/>
              <a:t>43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  <p:sp>
        <p:nvSpPr>
          <p:cNvPr id="42" name="TextBox 41"/>
          <p:cNvSpPr txBox="1"/>
          <p:nvPr/>
        </p:nvSpPr>
        <p:spPr>
          <a:xfrm>
            <a:off x="1191099" y="3915078"/>
            <a:ext cx="604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/>
              <a:t>34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  <p:sp>
        <p:nvSpPr>
          <p:cNvPr id="43" name="TextBox 42"/>
          <p:cNvSpPr txBox="1"/>
          <p:nvPr/>
        </p:nvSpPr>
        <p:spPr>
          <a:xfrm>
            <a:off x="1191099" y="3074677"/>
            <a:ext cx="604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/>
              <a:t>95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  <p:sp>
        <p:nvSpPr>
          <p:cNvPr id="44" name="TextBox 43"/>
          <p:cNvSpPr txBox="1"/>
          <p:nvPr/>
        </p:nvSpPr>
        <p:spPr>
          <a:xfrm>
            <a:off x="1191099" y="2921498"/>
            <a:ext cx="604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/>
              <a:t>130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  <p:sp>
        <p:nvSpPr>
          <p:cNvPr id="45" name="TextBox 44"/>
          <p:cNvSpPr txBox="1"/>
          <p:nvPr/>
        </p:nvSpPr>
        <p:spPr>
          <a:xfrm>
            <a:off x="1191099" y="2789488"/>
            <a:ext cx="604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/>
              <a:t>170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  <p:cxnSp>
        <p:nvCxnSpPr>
          <p:cNvPr id="46" name="Straight Connector 45"/>
          <p:cNvCxnSpPr/>
          <p:nvPr/>
        </p:nvCxnSpPr>
        <p:spPr>
          <a:xfrm flipH="1" flipV="1">
            <a:off x="1742816" y="4922536"/>
            <a:ext cx="233020" cy="28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194299" y="4805729"/>
            <a:ext cx="604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/>
              <a:t>43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2176383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8579" y="1898667"/>
            <a:ext cx="1984000" cy="2034286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8447" y="1898667"/>
            <a:ext cx="1984000" cy="2034286"/>
          </a:xfrm>
          <a:prstGeom prst="rect">
            <a:avLst/>
          </a:prstGeom>
        </p:spPr>
      </p:pic>
      <p:grpSp>
        <p:nvGrpSpPr>
          <p:cNvPr id="16" name="Group 15"/>
          <p:cNvGrpSpPr/>
          <p:nvPr/>
        </p:nvGrpSpPr>
        <p:grpSpPr>
          <a:xfrm>
            <a:off x="1744579" y="1430736"/>
            <a:ext cx="3870437" cy="2971933"/>
            <a:chOff x="6679805" y="3349480"/>
            <a:chExt cx="3870437" cy="2971933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485803" y="3973707"/>
              <a:ext cx="317799" cy="291316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6760628" y="3349480"/>
              <a:ext cx="7251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/>
                <a:t>Control</a:t>
              </a:r>
              <a:endParaRPr lang="en-US" sz="14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9592126" y="3349480"/>
              <a:ext cx="4318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/>
                <a:t>Pro</a:t>
              </a:r>
              <a:endParaRPr lang="en-US" sz="1400" dirty="0"/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232443" y="3973707"/>
              <a:ext cx="317799" cy="291316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6679805" y="5813582"/>
              <a:ext cx="886781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G0/G1: 57.03%</a:t>
              </a:r>
            </a:p>
            <a:p>
              <a:r>
                <a:rPr lang="en-US" sz="900" dirty="0"/>
                <a:t>S: 34.70</a:t>
              </a:r>
              <a:r>
                <a:rPr lang="en-US" sz="900" dirty="0" smtClean="0"/>
                <a:t>%</a:t>
              </a:r>
            </a:p>
            <a:p>
              <a:r>
                <a:rPr lang="en-US" sz="900" dirty="0" smtClean="0"/>
                <a:t>G2/M: 8.27%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9364661" y="5813582"/>
              <a:ext cx="886781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G0/G1: 33.36%</a:t>
              </a:r>
            </a:p>
            <a:p>
              <a:r>
                <a:rPr lang="en-US" sz="900" dirty="0"/>
                <a:t>S: 54.74</a:t>
              </a:r>
              <a:r>
                <a:rPr lang="en-US" sz="900" dirty="0" smtClean="0"/>
                <a:t>%</a:t>
              </a:r>
            </a:p>
            <a:p>
              <a:r>
                <a:rPr lang="en-US" sz="900" dirty="0" smtClean="0"/>
                <a:t>G2/M: 11.90%</a:t>
              </a:r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2697533" y="1186275"/>
            <a:ext cx="18123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/>
              <a:t>mEERL</a:t>
            </a:r>
            <a:r>
              <a:rPr lang="en-US" sz="1400" b="1" dirty="0" smtClean="0"/>
              <a:t>	</a:t>
            </a:r>
            <a:endParaRPr lang="en-US" sz="1400" b="1" dirty="0"/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55975" y="1901729"/>
            <a:ext cx="1984000" cy="2034286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22082" y="1898667"/>
            <a:ext cx="1984000" cy="2034286"/>
          </a:xfrm>
          <a:prstGeom prst="rect">
            <a:avLst/>
          </a:prstGeom>
        </p:spPr>
      </p:pic>
      <p:grpSp>
        <p:nvGrpSpPr>
          <p:cNvPr id="48" name="Group 47"/>
          <p:cNvGrpSpPr/>
          <p:nvPr/>
        </p:nvGrpSpPr>
        <p:grpSpPr>
          <a:xfrm>
            <a:off x="6871975" y="1430736"/>
            <a:ext cx="3649981" cy="2971933"/>
            <a:chOff x="6931459" y="3012214"/>
            <a:chExt cx="3649981" cy="2971933"/>
          </a:xfrm>
        </p:grpSpPr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688451" y="3685830"/>
              <a:ext cx="317799" cy="291316"/>
            </a:xfrm>
            <a:prstGeom prst="rect">
              <a:avLst/>
            </a:prstGeom>
          </p:spPr>
        </p:pic>
        <p:sp>
          <p:nvSpPr>
            <p:cNvPr id="50" name="TextBox 49"/>
            <p:cNvSpPr txBox="1"/>
            <p:nvPr/>
          </p:nvSpPr>
          <p:spPr>
            <a:xfrm>
              <a:off x="7129124" y="3012214"/>
              <a:ext cx="11079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/>
                <a:t>Control	</a:t>
              </a:r>
              <a:endParaRPr lang="en-US" sz="14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9758699" y="3012214"/>
              <a:ext cx="4318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/>
                <a:t>Pro</a:t>
              </a:r>
            </a:p>
          </p:txBody>
        </p:sp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263641" y="3685830"/>
              <a:ext cx="317799" cy="291316"/>
            </a:xfrm>
            <a:prstGeom prst="rect">
              <a:avLst/>
            </a:prstGeom>
          </p:spPr>
        </p:pic>
        <p:sp>
          <p:nvSpPr>
            <p:cNvPr id="53" name="TextBox 52"/>
            <p:cNvSpPr txBox="1"/>
            <p:nvPr/>
          </p:nvSpPr>
          <p:spPr>
            <a:xfrm>
              <a:off x="6931459" y="5476316"/>
              <a:ext cx="886781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G0/G1: 24.94%</a:t>
              </a:r>
            </a:p>
            <a:p>
              <a:r>
                <a:rPr lang="en-US" sz="900" dirty="0"/>
                <a:t>S: 52.8</a:t>
              </a:r>
              <a:r>
                <a:rPr lang="en-US" sz="900" dirty="0" smtClean="0"/>
                <a:t>%</a:t>
              </a:r>
            </a:p>
            <a:p>
              <a:r>
                <a:rPr lang="en-US" sz="900" dirty="0" smtClean="0"/>
                <a:t>G2/M: 22.26%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9531234" y="5476316"/>
              <a:ext cx="886781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G0/G1: 30.64%</a:t>
              </a:r>
            </a:p>
            <a:p>
              <a:r>
                <a:rPr lang="en-US" sz="900" dirty="0"/>
                <a:t>S: 43.67</a:t>
              </a:r>
              <a:r>
                <a:rPr lang="en-US" sz="900" dirty="0" smtClean="0"/>
                <a:t>%</a:t>
              </a:r>
            </a:p>
            <a:p>
              <a:r>
                <a:rPr lang="en-US" sz="900" dirty="0" smtClean="0"/>
                <a:t>G2/M: 25.70%</a:t>
              </a:r>
            </a:p>
          </p:txBody>
        </p:sp>
      </p:grpSp>
      <p:sp>
        <p:nvSpPr>
          <p:cNvPr id="55" name="TextBox 54"/>
          <p:cNvSpPr txBox="1"/>
          <p:nvPr/>
        </p:nvSpPr>
        <p:spPr>
          <a:xfrm>
            <a:off x="7886845" y="1186275"/>
            <a:ext cx="18123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MLM3	</a:t>
            </a:r>
            <a:endParaRPr lang="en-US" sz="14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940726" y="755056"/>
            <a:ext cx="542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56" name="TextBox 55"/>
          <p:cNvSpPr txBox="1"/>
          <p:nvPr/>
        </p:nvSpPr>
        <p:spPr>
          <a:xfrm>
            <a:off x="6150970" y="755056"/>
            <a:ext cx="542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57" name="Rectangle 56"/>
          <p:cNvSpPr/>
          <p:nvPr/>
        </p:nvSpPr>
        <p:spPr>
          <a:xfrm>
            <a:off x="3603718" y="4707232"/>
            <a:ext cx="5054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2</a:t>
            </a:r>
            <a:r>
              <a:rPr lang="en-US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Propranolol induces changes in cell cycle distribution.  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Representative histograms of PI cell cycle analysis of (A) </a:t>
            </a:r>
            <a:r>
              <a:rPr lang="en-US" sz="1200" dirty="0" err="1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EERL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nd (B) MLM3 cells treated with 40µM propranolol.  </a:t>
            </a:r>
            <a:endParaRPr lang="en-US" sz="1200" dirty="0">
              <a:latin typeface="Times New Roman" panose="020206030504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75083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5663" y="657726"/>
            <a:ext cx="4891873" cy="351064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7536" y="739369"/>
            <a:ext cx="4891872" cy="3429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71864" y="810126"/>
            <a:ext cx="1077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Control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363736" y="788746"/>
            <a:ext cx="1077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Pro</a:t>
            </a:r>
            <a:endParaRPr lang="en-US" b="1" dirty="0"/>
          </a:p>
        </p:txBody>
      </p:sp>
      <p:sp>
        <p:nvSpPr>
          <p:cNvPr id="8" name="Rectangle 7"/>
          <p:cNvSpPr/>
          <p:nvPr/>
        </p:nvSpPr>
        <p:spPr>
          <a:xfrm>
            <a:off x="3703320" y="4427019"/>
            <a:ext cx="45339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</a:t>
            </a:r>
            <a:r>
              <a:rPr lang="en-US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3: </a:t>
            </a:r>
            <a:r>
              <a:rPr lang="en-US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H&amp;E tumor sections. 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Representative tumor sections of control (left; scale bar = 5mm) or propranolol-treated mice (right; scale bar = 3mm).  Tumors were harvested at day 21 post-implantation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Tumor diameter in the longest dimension is shown in green.  </a:t>
            </a:r>
          </a:p>
          <a:p>
            <a:pPr algn="just"/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01340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5247974"/>
              </p:ext>
            </p:extLst>
          </p:nvPr>
        </p:nvGraphicFramePr>
        <p:xfrm>
          <a:off x="4517303" y="815992"/>
          <a:ext cx="3226666" cy="1731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Rectangle 1"/>
          <p:cNvSpPr/>
          <p:nvPr/>
        </p:nvSpPr>
        <p:spPr>
          <a:xfrm>
            <a:off x="4314702" y="2547640"/>
            <a:ext cx="363186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4</a:t>
            </a:r>
            <a:r>
              <a:rPr lang="en-US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aily propranolol does not affect parental </a:t>
            </a:r>
            <a:r>
              <a:rPr lang="en-US" sz="1200" b="1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EERL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tumor growth. 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verage tumor volume curves for mice implanted with parental </a:t>
            </a:r>
            <a:r>
              <a:rPr lang="en-US" sz="1200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EERL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tumors and treated daily with 2mg/kg IP propranolol or vehicle.  Each data point represents n = 10 mice.  Error bars = +/- SEM.</a:t>
            </a:r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09764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5118979"/>
              </p:ext>
            </p:extLst>
          </p:nvPr>
        </p:nvGraphicFramePr>
        <p:xfrm>
          <a:off x="4081463" y="1057275"/>
          <a:ext cx="421957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5"/>
          <p:cNvSpPr/>
          <p:nvPr/>
        </p:nvSpPr>
        <p:spPr>
          <a:xfrm>
            <a:off x="4254500" y="3800475"/>
            <a:ext cx="42926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</a:t>
            </a:r>
            <a:r>
              <a:rPr lang="en-US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5: </a:t>
            </a:r>
            <a:r>
              <a:rPr lang="en-US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aily propranolol alongside CRT does not lead to significant weight change versus standard of care CRT alone.  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ercent change in body mass (measured in grams) relative to baseline weight for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ice treated with 3 weekly rounds of CRT (arrows) plus 2 mg/kg daily IP propranolol (or vehicle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.  No statistically significant differences were measured between groups.  </a:t>
            </a:r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 flipV="1">
            <a:off x="5571770" y="2999975"/>
            <a:ext cx="0" cy="14668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V="1">
            <a:off x="6178404" y="2999975"/>
            <a:ext cx="0" cy="14668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V="1">
            <a:off x="6677392" y="2999975"/>
            <a:ext cx="0" cy="14668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877185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t="2510" r="84310" b="32636"/>
          <a:stretch/>
        </p:blipFill>
        <p:spPr bwMode="auto">
          <a:xfrm>
            <a:off x="5409486" y="2308336"/>
            <a:ext cx="506885" cy="13128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67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491" t="-227" r="23949" b="24275"/>
          <a:stretch/>
        </p:blipFill>
        <p:spPr bwMode="auto">
          <a:xfrm>
            <a:off x="6196652" y="735920"/>
            <a:ext cx="473913" cy="113810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grpSp>
        <p:nvGrpSpPr>
          <p:cNvPr id="16" name="Group 15"/>
          <p:cNvGrpSpPr/>
          <p:nvPr/>
        </p:nvGrpSpPr>
        <p:grpSpPr>
          <a:xfrm>
            <a:off x="5503937" y="1988935"/>
            <a:ext cx="812439" cy="1632259"/>
            <a:chOff x="2000188" y="3185810"/>
            <a:chExt cx="1925782" cy="3869052"/>
          </a:xfrm>
        </p:grpSpPr>
        <p:pic>
          <p:nvPicPr>
            <p:cNvPr id="1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854" t="8" r="34196" b="25448"/>
            <a:stretch/>
          </p:blipFill>
          <p:spPr bwMode="auto">
            <a:xfrm>
              <a:off x="3061942" y="3942904"/>
              <a:ext cx="761999" cy="311195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grpSp>
          <p:nvGrpSpPr>
            <p:cNvPr id="18" name="Group 17"/>
            <p:cNvGrpSpPr/>
            <p:nvPr/>
          </p:nvGrpSpPr>
          <p:grpSpPr>
            <a:xfrm>
              <a:off x="2198936" y="3380460"/>
              <a:ext cx="849422" cy="711308"/>
              <a:chOff x="1351819" y="506309"/>
              <a:chExt cx="929892" cy="779057"/>
            </a:xfrm>
          </p:grpSpPr>
          <p:sp>
            <p:nvSpPr>
              <p:cNvPr id="47" name="TextBox 46"/>
              <p:cNvSpPr txBox="1"/>
              <p:nvPr/>
            </p:nvSpPr>
            <p:spPr>
              <a:xfrm>
                <a:off x="1351819" y="506309"/>
                <a:ext cx="510796" cy="7790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85752"/>
                <a:r>
                  <a:rPr lang="en-US" sz="1350" b="1" dirty="0">
                    <a:solidFill>
                      <a:prstClr val="black"/>
                    </a:solidFill>
                    <a:latin typeface="Aharoni" panose="02010803020104030203" pitchFamily="2" charset="-79"/>
                    <a:cs typeface="Aharoni" panose="02010803020104030203" pitchFamily="2" charset="-79"/>
                  </a:rPr>
                  <a:t>-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770920" y="506312"/>
                <a:ext cx="510791" cy="779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85752"/>
                <a:r>
                  <a:rPr lang="en-US" sz="1350" b="1" dirty="0">
                    <a:solidFill>
                      <a:prstClr val="black"/>
                    </a:solidFill>
                    <a:latin typeface="Aharoni" panose="02010803020104030203" pitchFamily="2" charset="-79"/>
                    <a:cs typeface="Aharoni" panose="02010803020104030203" pitchFamily="2" charset="-79"/>
                  </a:rPr>
                  <a:t>+</a:t>
                </a: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3033896" y="3380457"/>
              <a:ext cx="844694" cy="711306"/>
              <a:chOff x="-1858443" y="506302"/>
              <a:chExt cx="924716" cy="779054"/>
            </a:xfrm>
          </p:grpSpPr>
          <p:sp>
            <p:nvSpPr>
              <p:cNvPr id="37" name="TextBox 36"/>
              <p:cNvSpPr txBox="1"/>
              <p:nvPr/>
            </p:nvSpPr>
            <p:spPr>
              <a:xfrm>
                <a:off x="-1858443" y="506302"/>
                <a:ext cx="505614" cy="7790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85752"/>
                <a:r>
                  <a:rPr lang="en-US" sz="1350" dirty="0">
                    <a:solidFill>
                      <a:prstClr val="black"/>
                    </a:solidFill>
                    <a:latin typeface="Aharoni" panose="02010803020104030203" pitchFamily="2" charset="-79"/>
                    <a:cs typeface="Aharoni" panose="02010803020104030203" pitchFamily="2" charset="-79"/>
                  </a:rPr>
                  <a:t>-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-1439341" y="506302"/>
                <a:ext cx="505614" cy="779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385752"/>
                <a:r>
                  <a:rPr lang="en-US" sz="1350" dirty="0">
                    <a:solidFill>
                      <a:prstClr val="black"/>
                    </a:solidFill>
                    <a:latin typeface="Aharoni" panose="02010803020104030203" pitchFamily="2" charset="-79"/>
                    <a:cs typeface="Aharoni" panose="02010803020104030203" pitchFamily="2" charset="-79"/>
                  </a:rPr>
                  <a:t>+</a:t>
                </a:r>
              </a:p>
            </p:txBody>
          </p:sp>
        </p:grpSp>
        <p:sp>
          <p:nvSpPr>
            <p:cNvPr id="28" name="TextBox 27"/>
            <p:cNvSpPr txBox="1"/>
            <p:nvPr/>
          </p:nvSpPr>
          <p:spPr>
            <a:xfrm>
              <a:off x="2000188" y="3185810"/>
              <a:ext cx="1215472" cy="567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85752"/>
              <a:r>
                <a:rPr lang="en-US" sz="955" b="1" dirty="0">
                  <a:solidFill>
                    <a:prstClr val="black"/>
                  </a:solidFill>
                  <a:latin typeface="Calibri"/>
                </a:rPr>
                <a:t>MLM3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925332" y="3185810"/>
              <a:ext cx="1000638" cy="567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85752"/>
              <a:r>
                <a:rPr lang="en-US" sz="955" b="1" dirty="0">
                  <a:solidFill>
                    <a:prstClr val="black"/>
                  </a:solidFill>
                  <a:latin typeface="Calibri"/>
                </a:rPr>
                <a:t>3.43</a:t>
              </a: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6689684" y="505088"/>
            <a:ext cx="485881" cy="260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85752"/>
            <a:r>
              <a:rPr lang="en-US" sz="1091" dirty="0" err="1">
                <a:solidFill>
                  <a:prstClr val="black"/>
                </a:solidFill>
                <a:latin typeface="Calibri"/>
              </a:rPr>
              <a:t>DrdI</a:t>
            </a:r>
            <a:endParaRPr lang="en-US" sz="1091" dirty="0">
              <a:solidFill>
                <a:prstClr val="black"/>
              </a:solidFill>
              <a:latin typeface="Calibri"/>
            </a:endParaRPr>
          </a:p>
        </p:txBody>
      </p:sp>
      <p:cxnSp>
        <p:nvCxnSpPr>
          <p:cNvPr id="50" name="Straight Arrow Connector 49"/>
          <p:cNvCxnSpPr/>
          <p:nvPr/>
        </p:nvCxnSpPr>
        <p:spPr>
          <a:xfrm>
            <a:off x="5390937" y="2974906"/>
            <a:ext cx="192882" cy="0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4741284" y="2856267"/>
            <a:ext cx="977792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85752"/>
            <a:r>
              <a:rPr lang="en-US" sz="955" dirty="0">
                <a:solidFill>
                  <a:prstClr val="black"/>
                </a:solidFill>
                <a:latin typeface="Calibri"/>
              </a:rPr>
              <a:t>Full Length</a:t>
            </a:r>
          </a:p>
        </p:txBody>
      </p:sp>
      <p:pic>
        <p:nvPicPr>
          <p:cNvPr id="53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5" r="65579" b="24275"/>
          <a:stretch/>
        </p:blipFill>
        <p:spPr bwMode="auto">
          <a:xfrm>
            <a:off x="5402884" y="735920"/>
            <a:ext cx="756598" cy="113810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54" name="TextBox 53"/>
          <p:cNvSpPr txBox="1"/>
          <p:nvPr/>
        </p:nvSpPr>
        <p:spPr>
          <a:xfrm>
            <a:off x="5987697" y="486236"/>
            <a:ext cx="160735" cy="3022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85752"/>
            <a:r>
              <a:rPr lang="en-US" sz="1364" b="1" dirty="0">
                <a:solidFill>
                  <a:prstClr val="black"/>
                </a:solidFill>
                <a:latin typeface="Aharoni" panose="02010803020104030203" pitchFamily="2" charset="-79"/>
                <a:cs typeface="Aharoni" panose="02010803020104030203" pitchFamily="2" charset="-79"/>
              </a:rPr>
              <a:t>+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5746595" y="486236"/>
            <a:ext cx="160735" cy="3022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85752"/>
            <a:r>
              <a:rPr lang="en-US" sz="1364" b="1" dirty="0">
                <a:solidFill>
                  <a:prstClr val="black"/>
                </a:solidFill>
                <a:latin typeface="Aharoni" panose="02010803020104030203" pitchFamily="2" charset="-79"/>
                <a:cs typeface="Aharoni" panose="02010803020104030203" pitchFamily="2" charset="-79"/>
              </a:rPr>
              <a:t>-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6218083" y="486236"/>
            <a:ext cx="160735" cy="3022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85752"/>
            <a:r>
              <a:rPr lang="en-US" sz="1364" b="1" dirty="0">
                <a:solidFill>
                  <a:prstClr val="black"/>
                </a:solidFill>
                <a:latin typeface="Aharoni" panose="02010803020104030203" pitchFamily="2" charset="-79"/>
                <a:cs typeface="Aharoni" panose="02010803020104030203" pitchFamily="2" charset="-79"/>
              </a:rPr>
              <a:t>-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6465212" y="486236"/>
            <a:ext cx="160735" cy="3022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85752"/>
            <a:r>
              <a:rPr lang="en-US" sz="1364" b="1" dirty="0">
                <a:solidFill>
                  <a:prstClr val="black"/>
                </a:solidFill>
                <a:latin typeface="Aharoni" panose="02010803020104030203" pitchFamily="2" charset="-79"/>
                <a:cs typeface="Aharoni" panose="02010803020104030203" pitchFamily="2" charset="-79"/>
              </a:rPr>
              <a:t>+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638455" y="385388"/>
            <a:ext cx="560510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85752"/>
            <a:r>
              <a:rPr lang="en-US" sz="955" b="1" dirty="0">
                <a:solidFill>
                  <a:prstClr val="black"/>
                </a:solidFill>
                <a:latin typeface="Calibri"/>
              </a:rPr>
              <a:t>MLM3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6232692" y="385388"/>
            <a:ext cx="40183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85752"/>
            <a:r>
              <a:rPr lang="en-US" sz="955" b="1" dirty="0">
                <a:solidFill>
                  <a:prstClr val="black"/>
                </a:solidFill>
                <a:latin typeface="Calibri"/>
              </a:rPr>
              <a:t>1.9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6296149" y="2079719"/>
            <a:ext cx="470149" cy="260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85752"/>
            <a:r>
              <a:rPr lang="en-US" sz="1091" dirty="0" err="1">
                <a:solidFill>
                  <a:prstClr val="black"/>
                </a:solidFill>
                <a:latin typeface="Calibri"/>
              </a:rPr>
              <a:t>StuI</a:t>
            </a:r>
            <a:endParaRPr lang="en-US" sz="1091" dirty="0">
              <a:solidFill>
                <a:prstClr val="black"/>
              </a:solidFill>
              <a:latin typeface="Calibri"/>
            </a:endParaRPr>
          </a:p>
        </p:txBody>
      </p:sp>
      <p:cxnSp>
        <p:nvCxnSpPr>
          <p:cNvPr id="64" name="Straight Arrow Connector 63"/>
          <p:cNvCxnSpPr/>
          <p:nvPr/>
        </p:nvCxnSpPr>
        <p:spPr>
          <a:xfrm>
            <a:off x="5473348" y="1446611"/>
            <a:ext cx="225028" cy="0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4783574" y="1347980"/>
            <a:ext cx="785820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85752"/>
            <a:r>
              <a:rPr lang="en-US" sz="955" dirty="0">
                <a:solidFill>
                  <a:prstClr val="black"/>
                </a:solidFill>
                <a:latin typeface="Calibri"/>
              </a:rPr>
              <a:t>Full length 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661274" y="131029"/>
            <a:ext cx="512540" cy="2811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27" dirty="0"/>
              <a:t>A.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525947" y="1918070"/>
            <a:ext cx="783196" cy="2811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27" dirty="0"/>
              <a:t>B.</a:t>
            </a:r>
          </a:p>
        </p:txBody>
      </p:sp>
      <p:pic>
        <p:nvPicPr>
          <p:cNvPr id="75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" contrast="-5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3539" t="69536" r="18265" b="14950"/>
          <a:stretch/>
        </p:blipFill>
        <p:spPr bwMode="auto">
          <a:xfrm>
            <a:off x="6051177" y="4005944"/>
            <a:ext cx="294906" cy="4298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7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" contrast="-5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590" t="70665" r="63964" b="15906"/>
          <a:stretch/>
        </p:blipFill>
        <p:spPr bwMode="auto">
          <a:xfrm>
            <a:off x="5704113" y="4005945"/>
            <a:ext cx="294849" cy="42986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2" name="Picture 71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39" r="86738"/>
          <a:stretch/>
        </p:blipFill>
        <p:spPr bwMode="auto">
          <a:xfrm>
            <a:off x="5339769" y="4485670"/>
            <a:ext cx="301818" cy="33364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3" name="Picture 72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49" t="9855" r="64623" b="3459"/>
          <a:stretch/>
        </p:blipFill>
        <p:spPr bwMode="auto">
          <a:xfrm>
            <a:off x="5699329" y="4485670"/>
            <a:ext cx="299632" cy="33364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4" name="Picture 73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07" t="1184" r="10196" b="1"/>
          <a:stretch/>
        </p:blipFill>
        <p:spPr bwMode="auto">
          <a:xfrm>
            <a:off x="6052886" y="4485670"/>
            <a:ext cx="293195" cy="33364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46" name="Group 45"/>
          <p:cNvGrpSpPr/>
          <p:nvPr/>
        </p:nvGrpSpPr>
        <p:grpSpPr>
          <a:xfrm>
            <a:off x="5324885" y="4801739"/>
            <a:ext cx="1011856" cy="553043"/>
            <a:chOff x="1068260" y="3545567"/>
            <a:chExt cx="3350447" cy="1570295"/>
          </a:xfrm>
        </p:grpSpPr>
        <p:sp>
          <p:nvSpPr>
            <p:cNvPr id="66" name="TextBox 65"/>
            <p:cNvSpPr txBox="1"/>
            <p:nvPr/>
          </p:nvSpPr>
          <p:spPr>
            <a:xfrm rot="18270179">
              <a:off x="665471" y="3990568"/>
              <a:ext cx="1528083" cy="7225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85752"/>
              <a:r>
                <a:rPr lang="en-US" sz="818" b="1" dirty="0">
                  <a:solidFill>
                    <a:prstClr val="black"/>
                  </a:solidFill>
                  <a:latin typeface="Calibri"/>
                </a:rPr>
                <a:t>MLM3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 rot="18270179">
              <a:off x="2388515" y="3829648"/>
              <a:ext cx="990599" cy="722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85752"/>
              <a:r>
                <a:rPr lang="en-US" sz="818" b="1" dirty="0">
                  <a:solidFill>
                    <a:prstClr val="black"/>
                  </a:solidFill>
                  <a:latin typeface="Calibri"/>
                </a:rPr>
                <a:t>1.9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 rot="18270179">
              <a:off x="3479905" y="3761865"/>
              <a:ext cx="1155100" cy="7225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85752"/>
              <a:r>
                <a:rPr lang="en-US" sz="818" b="1" dirty="0">
                  <a:solidFill>
                    <a:prstClr val="black"/>
                  </a:solidFill>
                  <a:latin typeface="Calibri"/>
                </a:rPr>
                <a:t>3.43</a:t>
              </a:r>
            </a:p>
          </p:txBody>
        </p:sp>
      </p:grpSp>
      <p:cxnSp>
        <p:nvCxnSpPr>
          <p:cNvPr id="52" name="Straight Connector 51"/>
          <p:cNvCxnSpPr/>
          <p:nvPr/>
        </p:nvCxnSpPr>
        <p:spPr>
          <a:xfrm>
            <a:off x="5718213" y="5181327"/>
            <a:ext cx="6009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5638454" y="5215301"/>
            <a:ext cx="769258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85752"/>
            <a:r>
              <a:rPr lang="el-GR" sz="818" b="1" dirty="0">
                <a:solidFill>
                  <a:prstClr val="black"/>
                </a:solidFill>
                <a:latin typeface="Calibri"/>
                <a:cs typeface="Calibri"/>
              </a:rPr>
              <a:t>β</a:t>
            </a:r>
            <a:r>
              <a:rPr lang="en-US" sz="818" b="1" baseline="-25000" dirty="0">
                <a:solidFill>
                  <a:prstClr val="black"/>
                </a:solidFill>
                <a:latin typeface="Calibri"/>
                <a:cs typeface="Calibri"/>
              </a:rPr>
              <a:t>2</a:t>
            </a:r>
            <a:r>
              <a:rPr lang="en-US" sz="818" b="1" dirty="0">
                <a:solidFill>
                  <a:prstClr val="black"/>
                </a:solidFill>
                <a:latin typeface="Calibri"/>
                <a:cs typeface="Calibri"/>
              </a:rPr>
              <a:t>AR Null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6359242" y="4169965"/>
            <a:ext cx="1016918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85752"/>
            <a:r>
              <a:rPr lang="el-GR" sz="818" b="1" dirty="0" smtClean="0">
                <a:solidFill>
                  <a:prstClr val="black"/>
                </a:solidFill>
                <a:latin typeface="Calibri"/>
                <a:cs typeface="Calibri"/>
              </a:rPr>
              <a:t>β</a:t>
            </a:r>
            <a:r>
              <a:rPr lang="en-US" sz="818" b="1" dirty="0" smtClean="0">
                <a:solidFill>
                  <a:prstClr val="black"/>
                </a:solidFill>
                <a:latin typeface="Calibri"/>
                <a:cs typeface="Calibri"/>
              </a:rPr>
              <a:t>2AR</a:t>
            </a:r>
            <a:endParaRPr lang="en-US" sz="818" b="1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359243" y="4577664"/>
            <a:ext cx="1016917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85752"/>
            <a:r>
              <a:rPr lang="en-US" sz="818" b="1" dirty="0" smtClean="0">
                <a:solidFill>
                  <a:prstClr val="black"/>
                </a:solidFill>
                <a:latin typeface="Calibri"/>
                <a:cs typeface="Calibri"/>
              </a:rPr>
              <a:t>Tubulin</a:t>
            </a:r>
            <a:endParaRPr lang="en-US" sz="818" b="1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525947" y="3668781"/>
            <a:ext cx="783196" cy="2811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27" dirty="0"/>
              <a:t>C.</a:t>
            </a:r>
          </a:p>
        </p:txBody>
      </p:sp>
      <p:sp>
        <p:nvSpPr>
          <p:cNvPr id="2" name="Rectangle 1"/>
          <p:cNvSpPr/>
          <p:nvPr/>
        </p:nvSpPr>
        <p:spPr>
          <a:xfrm>
            <a:off x="2003391" y="5409814"/>
            <a:ext cx="7886700" cy="15234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</a:t>
            </a:r>
            <a:r>
              <a:rPr lang="en-US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6: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creening of </a:t>
            </a:r>
            <a:r>
              <a:rPr lang="el-GR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β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AR CRISPR clones. 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Gel electrophoresis showing the restriction enzyme digest products of (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early exon target clone (</a:t>
            </a:r>
            <a:r>
              <a:rPr lang="el-GR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β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AR null 1.9) and (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middle exon target clone (</a:t>
            </a:r>
            <a:r>
              <a:rPr lang="el-GR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β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AR null 3.43).  As depicted in the images, </a:t>
            </a:r>
            <a:r>
              <a:rPr lang="en-US" sz="1200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wildtype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MLM3) PCR products display two DNA bands following digest, while bi-allelic mutants (1.9 and 3.43) display only one, indicating successful mutation of targeted restriction enzyme sequence.  (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Western blot analysis of RFLP-positive clones, showing a lack of signal in </a:t>
            </a:r>
            <a:r>
              <a:rPr lang="el-GR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β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AR null clones 1.9 and 3.43.  Images were cropped to remove unused clones.  All cropped images in a given figure come from the </a:t>
            </a:r>
            <a:r>
              <a:rPr lang="en-US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ame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el/membrane and brightness/contrast have not been altered separately.  </a:t>
            </a:r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 </a:t>
            </a:r>
          </a:p>
        </p:txBody>
      </p:sp>
      <p:pic>
        <p:nvPicPr>
          <p:cNvPr id="76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" contrast="-5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026" t="70602" r="72199" b="14058"/>
          <a:stretch/>
        </p:blipFill>
        <p:spPr bwMode="auto">
          <a:xfrm>
            <a:off x="5339769" y="4005944"/>
            <a:ext cx="298685" cy="43270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" name="Straight Connector 3"/>
          <p:cNvCxnSpPr/>
          <p:nvPr/>
        </p:nvCxnSpPr>
        <p:spPr>
          <a:xfrm flipH="1">
            <a:off x="5110415" y="4414065"/>
            <a:ext cx="22052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4174733" y="4304965"/>
            <a:ext cx="1016917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385752"/>
            <a:r>
              <a:rPr lang="en-US" sz="818" dirty="0" smtClean="0">
                <a:solidFill>
                  <a:prstClr val="black"/>
                </a:solidFill>
                <a:latin typeface="Calibri"/>
                <a:cs typeface="Calibri"/>
              </a:rPr>
              <a:t>43kDa</a:t>
            </a:r>
            <a:endParaRPr lang="en-US" sz="818" dirty="0">
              <a:solidFill>
                <a:prstClr val="black"/>
              </a:solidFill>
              <a:latin typeface="Calibri"/>
              <a:cs typeface="Calibri"/>
            </a:endParaRPr>
          </a:p>
        </p:txBody>
      </p:sp>
      <p:cxnSp>
        <p:nvCxnSpPr>
          <p:cNvPr id="81" name="Straight Connector 80"/>
          <p:cNvCxnSpPr/>
          <p:nvPr/>
        </p:nvCxnSpPr>
        <p:spPr>
          <a:xfrm flipH="1">
            <a:off x="5110415" y="4634785"/>
            <a:ext cx="22052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4174733" y="4525684"/>
            <a:ext cx="1016917" cy="218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385752"/>
            <a:r>
              <a:rPr lang="en-US" sz="818" dirty="0" smtClean="0">
                <a:solidFill>
                  <a:prstClr val="black"/>
                </a:solidFill>
                <a:latin typeface="Calibri"/>
                <a:cs typeface="Calibri"/>
              </a:rPr>
              <a:t>55kDa</a:t>
            </a:r>
            <a:endParaRPr lang="en-US" sz="818" dirty="0">
              <a:solidFill>
                <a:prstClr val="black"/>
              </a:solidFill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530615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38355" y="609600"/>
            <a:ext cx="3603459" cy="3289300"/>
            <a:chOff x="0" y="38100"/>
            <a:chExt cx="4800600" cy="353060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8100"/>
              <a:ext cx="4800600" cy="35306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0" y="152400"/>
              <a:ext cx="10776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MLM3</a:t>
              </a:r>
              <a:endParaRPr lang="en-US" b="1" dirty="0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4234168" y="609600"/>
            <a:ext cx="3603459" cy="3289300"/>
            <a:chOff x="-126272" y="3568700"/>
            <a:chExt cx="4926872" cy="328930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568700"/>
              <a:ext cx="4800600" cy="32893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-126272" y="3729166"/>
              <a:ext cx="14956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b="1" dirty="0" smtClean="0">
                  <a:ea typeface="MS Mincho" panose="02020609040205080304" pitchFamily="49" charset="-128"/>
                </a:rPr>
                <a:t>β</a:t>
              </a:r>
              <a:r>
                <a:rPr lang="en-US" b="1" dirty="0" smtClean="0">
                  <a:ea typeface="MS Mincho" panose="02020609040205080304" pitchFamily="49" charset="-128"/>
                </a:rPr>
                <a:t>2AR Null</a:t>
              </a:r>
              <a:endParaRPr lang="en-US" b="1" dirty="0" smtClean="0"/>
            </a:p>
            <a:p>
              <a:pPr algn="ctr"/>
              <a:r>
                <a:rPr lang="en-US" b="1" dirty="0" smtClean="0"/>
                <a:t>1.9</a:t>
              </a:r>
              <a:endParaRPr lang="en-US" b="1" dirty="0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7929981" y="666750"/>
            <a:ext cx="3511105" cy="3175000"/>
            <a:chOff x="4800599" y="152400"/>
            <a:chExt cx="4800601" cy="34163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00600" y="279400"/>
              <a:ext cx="4800600" cy="32893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4800599" y="152400"/>
              <a:ext cx="145732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b="1" dirty="0">
                  <a:ea typeface="MS Mincho" panose="02020609040205080304" pitchFamily="49" charset="-128"/>
                </a:rPr>
                <a:t>β</a:t>
              </a:r>
              <a:r>
                <a:rPr lang="en-US" b="1" dirty="0" smtClean="0">
                  <a:ea typeface="MS Mincho" panose="02020609040205080304" pitchFamily="49" charset="-128"/>
                </a:rPr>
                <a:t>2AR Null 3.43</a:t>
              </a:r>
              <a:endParaRPr lang="en-US" b="1" dirty="0"/>
            </a:p>
          </p:txBody>
        </p:sp>
      </p:grpSp>
      <p:sp>
        <p:nvSpPr>
          <p:cNvPr id="11" name="Rectangle 10"/>
          <p:cNvSpPr/>
          <p:nvPr/>
        </p:nvSpPr>
        <p:spPr>
          <a:xfrm>
            <a:off x="2899852" y="4474756"/>
            <a:ext cx="6096000" cy="83099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7: H&amp;E tumor sections. 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Representative tumor sections of MLM3 (left; scale bar = 5mm), </a:t>
            </a:r>
            <a:r>
              <a:rPr lang="el-GR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β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AR Null 1.9 (middle; scale bar = 2mm), and  </a:t>
            </a:r>
            <a:r>
              <a:rPr lang="el-GR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β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AR Null 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3.43 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(middle; scale bar = 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4mm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 Tumors were harvested at day 21 post-implantation.  Tumor diameter in the longest dimension is shown in green.  </a:t>
            </a:r>
            <a:endParaRPr lang="en-US" sz="1200" dirty="0">
              <a:latin typeface="Times New Roman" panose="020206030504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44929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223" t="50929" r="22519" b="44845"/>
          <a:stretch/>
        </p:blipFill>
        <p:spPr>
          <a:xfrm flipH="1">
            <a:off x="4898568" y="2057400"/>
            <a:ext cx="1730831" cy="5429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5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087" t="57374" r="16344" b="36004"/>
          <a:stretch/>
        </p:blipFill>
        <p:spPr>
          <a:xfrm flipH="1">
            <a:off x="4898569" y="2721429"/>
            <a:ext cx="1722888" cy="5660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6619239" y="2140355"/>
            <a:ext cx="17243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AR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619238" y="2809666"/>
            <a:ext cx="21285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773320" y="1322065"/>
            <a:ext cx="10035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l-G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AR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64110" y="1328058"/>
            <a:ext cx="8446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3856745" y="3457572"/>
            <a:ext cx="489101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8</a:t>
            </a:r>
            <a:r>
              <a:rPr lang="en-US" sz="1200" b="1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</a:t>
            </a:r>
            <a:r>
              <a:rPr lang="el-G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AR antibody validatio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Western blot depicting </a:t>
            </a:r>
            <a:r>
              <a:rPr lang="en-US" sz="1200" dirty="0" err="1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EERL</a:t>
            </a:r>
            <a:r>
              <a:rPr lang="en-US" sz="1200" dirty="0" smtClean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left) overexpressing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A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right) for validation of sc-569 anti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A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body.  </a:t>
            </a:r>
            <a:endParaRPr lang="en-US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 flipH="1">
            <a:off x="4441375" y="2590799"/>
            <a:ext cx="44631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693462" y="2436911"/>
            <a:ext cx="827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43 </a:t>
            </a:r>
            <a:r>
              <a:rPr lang="en-US" sz="1400" dirty="0" err="1" smtClean="0"/>
              <a:t>kDa</a:t>
            </a:r>
            <a:endParaRPr lang="en-US" sz="1400" dirty="0"/>
          </a:p>
        </p:txBody>
      </p:sp>
      <p:cxnSp>
        <p:nvCxnSpPr>
          <p:cNvPr id="15" name="Straight Connector 14"/>
          <p:cNvCxnSpPr/>
          <p:nvPr/>
        </p:nvCxnSpPr>
        <p:spPr>
          <a:xfrm flipH="1">
            <a:off x="4441375" y="3062287"/>
            <a:ext cx="44631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693462" y="2908399"/>
            <a:ext cx="827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34 </a:t>
            </a:r>
            <a:r>
              <a:rPr lang="en-US" sz="1400" dirty="0" err="1" smtClean="0"/>
              <a:t>kDa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968706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2007-2010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 2007-2010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8507</TotalTime>
  <Words>974</Words>
  <Application>Microsoft Office PowerPoint</Application>
  <PresentationFormat>Widescreen</PresentationFormat>
  <Paragraphs>118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6" baseType="lpstr">
      <vt:lpstr>MS Mincho</vt:lpstr>
      <vt:lpstr>Aharoni</vt:lpstr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anford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ido, Chris Thomas</dc:creator>
  <cp:lastModifiedBy>Lucido,Chris</cp:lastModifiedBy>
  <cp:revision>106</cp:revision>
  <dcterms:created xsi:type="dcterms:W3CDTF">2018-05-30T15:23:19Z</dcterms:created>
  <dcterms:modified xsi:type="dcterms:W3CDTF">2018-08-03T14:32:31Z</dcterms:modified>
</cp:coreProperties>
</file>